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55"/>
  </p:normalViewPr>
  <p:slideViewPr>
    <p:cSldViewPr snapToGrid="0" snapToObjects="1">
      <p:cViewPr varScale="1">
        <p:scale>
          <a:sx n="100" d="100"/>
          <a:sy n="100" d="100"/>
        </p:scale>
        <p:origin x="46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D46891-91CD-C14A-8BEC-DE31C572F4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683BF08-3A3E-3542-9562-35D09BFE509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2141B5-0E72-EC45-B7F5-544D2F2C45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477643-16F7-2243-AF9B-272B95CD8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D9FFA9-9418-CE41-91D4-F342EC326A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0590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AAA50-FE14-9D4E-9BF5-5D79AB3AAA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9EE799-8418-3444-86BD-75010DF27A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E85DF5-6CDA-3542-8681-7A8D571C8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A4E52C8-27B1-F141-9E5F-325C21FE53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9006DD-10AF-D542-947E-04A1E09CE0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470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F9BA70-C2E0-8D4C-90C3-1A1864B0A07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729E50-CB5B-B748-99EC-E713A7A2B9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039C0E8-907A-7043-BE85-D565A675D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3F1DCC-7119-B247-B544-709B26E3C4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0866CE-2E4A-9B4B-8570-5F92156401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792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71504B8-53D8-A541-9D1A-F533BCF0E1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96AF6-BB0F-2B4C-B36F-70D047FAFC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B508F3-6DDD-8C4C-8B17-189DA3DCDE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65CB59-6AE4-6A49-BF90-37B1F6AEA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444568-D7A3-FE45-A67A-1EE474E77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088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486C2B-E710-C548-AA9E-1570246C06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2041AA-0520-FC44-BFA9-4DCE3C632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D5ECD4-3909-C34B-AA8D-079141824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89DF45-3CBC-8242-AC6B-54153E480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BAE08D-B428-0243-B866-9210787F1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16180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84B444-91B3-4543-B472-F5F92487A9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2279B2-9BB4-F849-8B7A-81FFD28324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2143BD3-37FB-614E-AA7B-BD82684222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F4674E-84DB-2349-9633-03EEF98B5B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14DDE8-DA43-3C48-A8D6-FDD498B30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2A66E1-6ECC-1C49-8597-D8BEAFDDFA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864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12F43C-D2DB-0B4D-936E-5F915FB3D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24247B-0622-0041-B4CB-3E16F410AA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3B7F3B-7467-7941-9A4D-6DCCADA432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A6C344-6E28-B54E-8FBC-FB4F3401D17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EB63B34-ED24-3A48-9EC0-DD033F5791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48CF70-0737-AF4D-AD0E-8EE5089EE1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A55AB30-0D18-D943-9EC6-167F875FF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5D7AC65-AF88-F742-9A82-1932838FDD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2738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F5173D-EFDA-C449-BD25-8D5F394C95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4923F6E-63C7-CD4C-A013-B426E43D4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45041D8-ED6D-3C4D-A36A-D0D36807FC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281328-066C-D64F-BAB7-02D827FA98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332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56B4FE-5BD2-0440-A2F7-79742860D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BFE4F8-D573-6B47-8B50-964E50BAE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388E7D-D133-CE4B-BEBD-F3E87AB411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274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520A4A-31B4-BC4D-8473-4C91AA2729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220607-1749-F84C-87AC-556B1141272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6D144D-1212-984A-99CC-A948356941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AD9C61-34AD-904F-B98C-64483D477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ACAE91-96F0-0D4E-BA59-94FA849D95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F718E4-29A4-7649-A9C5-39A489A549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582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09A448-A134-A14F-9524-7A672B117C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A237B0-3187-7D4E-8559-345D297AB3E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9BEFAF-F400-EE46-8E69-8077AD4716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63B97A-197A-2F4E-91FB-3B9F4F624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30152C-76D2-DF4F-8636-122F12515C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CB4F19-9BE6-B944-A6CD-1D254FA6E6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759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91988A-44FD-BC47-8805-C908D11D92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956515-4404-8A41-A22D-8269313FE5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593997-CFEA-C147-BF4B-E146618070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6CC093-428F-3E48-B9C0-DFBEFDCA0B6D}" type="datetimeFigureOut">
              <a:rPr lang="en-US" smtClean="0"/>
              <a:t>7/1/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8BB47A-31E9-2840-A4CC-4D06B0A77D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5DECBF-E443-B941-92F3-89A6632E25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2C55D-15A4-AB47-AC68-5ACC176C5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41536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tif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6BE5A7D5-94CD-0648-A2F3-A307806D4A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18861" y="217631"/>
            <a:ext cx="1181711" cy="124762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E148DD3-3D24-5C46-8281-6B7923B5B9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22901" y="223543"/>
            <a:ext cx="1244413" cy="1124136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E5834007-07D4-1C4A-A4CB-C9CE9016454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6836" y="168098"/>
            <a:ext cx="1214543" cy="117583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CF8EA03-ABBE-9344-BE1F-2193AE57FE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95690" y="1402862"/>
            <a:ext cx="1239590" cy="1200081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2B49142-4B30-D845-9F7C-3A87DE3F6D1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35279" y="1376283"/>
            <a:ext cx="1270455" cy="1229963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F796E76-D7AD-8845-BB10-9059289598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63031" y="1397094"/>
            <a:ext cx="1195060" cy="1185537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1946393B-1D9C-104D-B1AC-EFE3B91B7F6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65640" y="2690523"/>
            <a:ext cx="1257261" cy="1217189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22514147-44B0-3440-B53F-482F2DB375C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85910" y="2680235"/>
            <a:ext cx="1277800" cy="123707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F991D7B-3DA6-8C45-B19F-7D32CD972C8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573358" y="4004926"/>
            <a:ext cx="1287997" cy="1246946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6A99721-394C-F543-8660-A9F41471988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521691" y="2658126"/>
            <a:ext cx="1269506" cy="122904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6ECAE1C-AED2-5442-B2CA-FCAF52F2BC6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861356" y="4023963"/>
            <a:ext cx="1256851" cy="1216792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4634DF2-582C-344D-B0F8-3CCA8A98D1F9}"/>
              </a:ext>
            </a:extLst>
          </p:cNvPr>
          <p:cNvSpPr txBox="1"/>
          <p:nvPr/>
        </p:nvSpPr>
        <p:spPr>
          <a:xfrm>
            <a:off x="4523747" y="5413895"/>
            <a:ext cx="3839962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en-US" sz="563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E303A5D7-E22E-F946-B84C-9D3C5FD17F88}"/>
              </a:ext>
            </a:extLst>
          </p:cNvPr>
          <p:cNvGrpSpPr/>
          <p:nvPr/>
        </p:nvGrpSpPr>
        <p:grpSpPr>
          <a:xfrm>
            <a:off x="7434061" y="4102360"/>
            <a:ext cx="823824" cy="827120"/>
            <a:chOff x="4828328" y="338408"/>
            <a:chExt cx="823824" cy="827120"/>
          </a:xfrm>
        </p:grpSpPr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3CE51BDD-38AF-9B4F-AF37-CA630F54E2D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79886" y="441879"/>
              <a:ext cx="0" cy="467520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8A7D0E35-70B9-0542-90B8-79A10CD1683F}"/>
                </a:ext>
              </a:extLst>
            </p:cNvPr>
            <p:cNvCxnSpPr>
              <a:cxnSpLocks/>
            </p:cNvCxnSpPr>
            <p:nvPr/>
          </p:nvCxnSpPr>
          <p:spPr>
            <a:xfrm>
              <a:off x="5086145" y="909399"/>
              <a:ext cx="535610" cy="0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4D8E0075-3C92-4B47-BDC9-E99EFC211505}"/>
                </a:ext>
              </a:extLst>
            </p:cNvPr>
            <p:cNvSpPr txBox="1"/>
            <p:nvPr/>
          </p:nvSpPr>
          <p:spPr>
            <a:xfrm rot="16200000">
              <a:off x="4594674" y="572062"/>
              <a:ext cx="732894" cy="2655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563" dirty="0">
                  <a:latin typeface="Arial" panose="020B0604020202020204" pitchFamily="34" charset="0"/>
                  <a:cs typeface="Arial" panose="020B0604020202020204" pitchFamily="34" charset="0"/>
                </a:rPr>
                <a:t>Gene expression</a:t>
              </a:r>
            </a:p>
            <a:p>
              <a:pPr algn="ctr"/>
              <a:r>
                <a:rPr lang="en-US" sz="563" dirty="0">
                  <a:latin typeface="Arial" panose="020B0604020202020204" pitchFamily="34" charset="0"/>
                  <a:cs typeface="Arial" panose="020B0604020202020204" pitchFamily="34" charset="0"/>
                </a:rPr>
                <a:t>FKPM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68086DDE-9D79-B348-8521-474425AEB2A3}"/>
                </a:ext>
              </a:extLst>
            </p:cNvPr>
            <p:cNvCxnSpPr>
              <a:cxnSpLocks/>
            </p:cNvCxnSpPr>
            <p:nvPr/>
          </p:nvCxnSpPr>
          <p:spPr>
            <a:xfrm>
              <a:off x="5181996" y="907685"/>
              <a:ext cx="0" cy="103374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>
              <a:extLst>
                <a:ext uri="{FF2B5EF4-FFF2-40B4-BE49-F238E27FC236}">
                  <a16:creationId xmlns:a16="http://schemas.microsoft.com/office/drawing/2014/main" id="{5EB1A011-4B2A-B847-A670-FCE0AB49D3B4}"/>
                </a:ext>
              </a:extLst>
            </p:cNvPr>
            <p:cNvCxnSpPr>
              <a:cxnSpLocks/>
            </p:cNvCxnSpPr>
            <p:nvPr/>
          </p:nvCxnSpPr>
          <p:spPr>
            <a:xfrm>
              <a:off x="5277848" y="905970"/>
              <a:ext cx="0" cy="103374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7B3D329E-DE24-BA47-BCB8-6CBDFC8097F9}"/>
                </a:ext>
              </a:extLst>
            </p:cNvPr>
            <p:cNvCxnSpPr>
              <a:cxnSpLocks/>
            </p:cNvCxnSpPr>
            <p:nvPr/>
          </p:nvCxnSpPr>
          <p:spPr>
            <a:xfrm>
              <a:off x="5363573" y="909399"/>
              <a:ext cx="0" cy="103374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BAF95306-7C64-8A4D-B8B5-4ECC340D88DC}"/>
                </a:ext>
              </a:extLst>
            </p:cNvPr>
            <p:cNvCxnSpPr>
              <a:cxnSpLocks/>
            </p:cNvCxnSpPr>
            <p:nvPr/>
          </p:nvCxnSpPr>
          <p:spPr>
            <a:xfrm>
              <a:off x="5449298" y="912828"/>
              <a:ext cx="0" cy="103374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EB708DA2-F049-5249-BB1D-856E5D1489A8}"/>
                </a:ext>
              </a:extLst>
            </p:cNvPr>
            <p:cNvCxnSpPr>
              <a:cxnSpLocks/>
            </p:cNvCxnSpPr>
            <p:nvPr/>
          </p:nvCxnSpPr>
          <p:spPr>
            <a:xfrm>
              <a:off x="5535023" y="905970"/>
              <a:ext cx="0" cy="103374"/>
            </a:xfrm>
            <a:prstGeom prst="line">
              <a:avLst/>
            </a:prstGeom>
            <a:ln w="12700"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2EC18EE-E521-0F4D-A087-B6E26FDBC23A}"/>
                </a:ext>
              </a:extLst>
            </p:cNvPr>
            <p:cNvSpPr txBox="1"/>
            <p:nvPr/>
          </p:nvSpPr>
          <p:spPr>
            <a:xfrm>
              <a:off x="5146885" y="986568"/>
              <a:ext cx="505267" cy="17896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563" dirty="0">
                  <a:latin typeface="Arial" panose="020B0604020202020204" pitchFamily="34" charset="0"/>
                  <a:cs typeface="Arial" panose="020B0604020202020204" pitchFamily="34" charset="0"/>
                </a:rPr>
                <a:t>Cell types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22BFE500-D227-E040-B400-577519CEE672}"/>
              </a:ext>
            </a:extLst>
          </p:cNvPr>
          <p:cNvSpPr txBox="1"/>
          <p:nvPr/>
        </p:nvSpPr>
        <p:spPr>
          <a:xfrm>
            <a:off x="6317616" y="226148"/>
            <a:ext cx="545342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HLAE****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A250726-A26B-7B4F-B733-9F0EB85E6CEC}"/>
              </a:ext>
            </a:extLst>
          </p:cNvPr>
          <p:cNvSpPr txBox="1"/>
          <p:nvPr/>
        </p:nvSpPr>
        <p:spPr>
          <a:xfrm>
            <a:off x="7541584" y="226148"/>
            <a:ext cx="497252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B2M****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B1D320D-B3DE-1D47-8232-76C877DF1A08}"/>
              </a:ext>
            </a:extLst>
          </p:cNvPr>
          <p:cNvSpPr txBox="1"/>
          <p:nvPr/>
        </p:nvSpPr>
        <p:spPr>
          <a:xfrm>
            <a:off x="5002625" y="152762"/>
            <a:ext cx="511679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VEGFA*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C8C70B1-3268-F048-B690-0682557E147F}"/>
              </a:ext>
            </a:extLst>
          </p:cNvPr>
          <p:cNvSpPr txBox="1"/>
          <p:nvPr/>
        </p:nvSpPr>
        <p:spPr>
          <a:xfrm>
            <a:off x="6317616" y="1425013"/>
            <a:ext cx="386644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IDO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3DB32EB-4F32-0A49-B896-3C1C1DB1F3E8}"/>
              </a:ext>
            </a:extLst>
          </p:cNvPr>
          <p:cNvSpPr txBox="1"/>
          <p:nvPr/>
        </p:nvSpPr>
        <p:spPr>
          <a:xfrm>
            <a:off x="7592853" y="1415109"/>
            <a:ext cx="386644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IDO2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0892F62-6A12-7944-939A-F22B95AA027B}"/>
              </a:ext>
            </a:extLst>
          </p:cNvPr>
          <p:cNvSpPr txBox="1"/>
          <p:nvPr/>
        </p:nvSpPr>
        <p:spPr>
          <a:xfrm>
            <a:off x="5071395" y="1384834"/>
            <a:ext cx="420308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ARG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3869ED1-2B50-5C4B-B0DB-2D707013324F}"/>
              </a:ext>
            </a:extLst>
          </p:cNvPr>
          <p:cNvSpPr txBox="1"/>
          <p:nvPr/>
        </p:nvSpPr>
        <p:spPr>
          <a:xfrm>
            <a:off x="6300934" y="2690523"/>
            <a:ext cx="554960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ARG2***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6589715-812E-3349-84ED-1E428D7CE761}"/>
              </a:ext>
            </a:extLst>
          </p:cNvPr>
          <p:cNvSpPr txBox="1"/>
          <p:nvPr/>
        </p:nvSpPr>
        <p:spPr>
          <a:xfrm>
            <a:off x="7485101" y="2679489"/>
            <a:ext cx="603050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PTGS2****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A636B9A-780D-A046-9844-466EFEA01F28}"/>
              </a:ext>
            </a:extLst>
          </p:cNvPr>
          <p:cNvSpPr txBox="1"/>
          <p:nvPr/>
        </p:nvSpPr>
        <p:spPr>
          <a:xfrm>
            <a:off x="5031085" y="4023963"/>
            <a:ext cx="627095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PECAM***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78B50DF2-50F8-B240-A8F2-121B1B80842B}"/>
              </a:ext>
            </a:extLst>
          </p:cNvPr>
          <p:cNvSpPr txBox="1"/>
          <p:nvPr/>
        </p:nvSpPr>
        <p:spPr>
          <a:xfrm>
            <a:off x="4999296" y="2658126"/>
            <a:ext cx="622286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NCAM1***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7B12A44-5FED-AF4A-9108-DFD1DFD6C273}"/>
              </a:ext>
            </a:extLst>
          </p:cNvPr>
          <p:cNvSpPr txBox="1"/>
          <p:nvPr/>
        </p:nvSpPr>
        <p:spPr>
          <a:xfrm>
            <a:off x="6319083" y="4023963"/>
            <a:ext cx="559769" cy="19620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GAPDH**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908A501-CBF1-4B4C-BA60-944FA149661D}"/>
              </a:ext>
            </a:extLst>
          </p:cNvPr>
          <p:cNvSpPr/>
          <p:nvPr/>
        </p:nvSpPr>
        <p:spPr>
          <a:xfrm>
            <a:off x="4561608" y="1100321"/>
            <a:ext cx="3705706" cy="2416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E6DEC3F-2D8F-654F-AA2F-56CD8B5FD6AA}"/>
              </a:ext>
            </a:extLst>
          </p:cNvPr>
          <p:cNvGrpSpPr/>
          <p:nvPr/>
        </p:nvGrpSpPr>
        <p:grpSpPr>
          <a:xfrm>
            <a:off x="5901534" y="1005082"/>
            <a:ext cx="1008665" cy="450390"/>
            <a:chOff x="2071294" y="10821065"/>
            <a:chExt cx="1793182" cy="800693"/>
          </a:xfrm>
        </p:grpSpPr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B0EAE3D-F22B-5F43-A1A0-B85561A9F5B0}"/>
                </a:ext>
              </a:extLst>
            </p:cNvPr>
            <p:cNvSpPr txBox="1"/>
            <p:nvPr/>
          </p:nvSpPr>
          <p:spPr>
            <a:xfrm rot="18413975">
              <a:off x="1897741" y="11035185"/>
              <a:ext cx="695919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BCA17FF-F1FA-F84F-BD03-187F1A32A2CF}"/>
                </a:ext>
              </a:extLst>
            </p:cNvPr>
            <p:cNvSpPr txBox="1"/>
            <p:nvPr/>
          </p:nvSpPr>
          <p:spPr>
            <a:xfrm rot="18413975">
              <a:off x="2135082" y="11031983"/>
              <a:ext cx="704467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81C86B4B-A43A-F145-B8CE-ED8F784B02AC}"/>
                </a:ext>
              </a:extLst>
            </p:cNvPr>
            <p:cNvSpPr txBox="1"/>
            <p:nvPr/>
          </p:nvSpPr>
          <p:spPr>
            <a:xfrm rot="18413975">
              <a:off x="2408743" y="11003478"/>
              <a:ext cx="66172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32A9231-6CDF-E749-BBB1-48CE0C236A9B}"/>
                </a:ext>
              </a:extLst>
            </p:cNvPr>
            <p:cNvSpPr txBox="1"/>
            <p:nvPr/>
          </p:nvSpPr>
          <p:spPr>
            <a:xfrm rot="18413975">
              <a:off x="2810759" y="11039503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293CD9C3-B3E0-5B4A-BEDF-B08A546208F0}"/>
                </a:ext>
              </a:extLst>
            </p:cNvPr>
            <p:cNvSpPr txBox="1"/>
            <p:nvPr/>
          </p:nvSpPr>
          <p:spPr>
            <a:xfrm rot="18413975">
              <a:off x="3251002" y="10960304"/>
              <a:ext cx="54203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B70B1E6-040D-2747-A51E-6E373A7B26C0}"/>
                </a:ext>
              </a:extLst>
            </p:cNvPr>
            <p:cNvSpPr txBox="1"/>
            <p:nvPr/>
          </p:nvSpPr>
          <p:spPr>
            <a:xfrm rot="18413975">
              <a:off x="3299363" y="11037364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36891D0E-AD2B-3E4D-A76B-599DC0DF59F2}"/>
                </a:ext>
              </a:extLst>
            </p:cNvPr>
            <p:cNvSpPr txBox="1"/>
            <p:nvPr/>
          </p:nvSpPr>
          <p:spPr>
            <a:xfrm rot="18413975">
              <a:off x="2585056" y="11060921"/>
              <a:ext cx="77286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id="{60D1FACB-4268-EE40-B557-A89F0A85E2FF}"/>
              </a:ext>
            </a:extLst>
          </p:cNvPr>
          <p:cNvGrpSpPr/>
          <p:nvPr/>
        </p:nvGrpSpPr>
        <p:grpSpPr>
          <a:xfrm>
            <a:off x="7176728" y="984504"/>
            <a:ext cx="1008665" cy="450390"/>
            <a:chOff x="2071294" y="10821065"/>
            <a:chExt cx="1793182" cy="800693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D7DA371E-86C2-F64D-8E7F-D3B092408AF6}"/>
                </a:ext>
              </a:extLst>
            </p:cNvPr>
            <p:cNvSpPr txBox="1"/>
            <p:nvPr/>
          </p:nvSpPr>
          <p:spPr>
            <a:xfrm rot="18413975">
              <a:off x="1897741" y="11035185"/>
              <a:ext cx="695919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01E4DA73-E075-E149-9EEC-BC7AF5DA2FBE}"/>
                </a:ext>
              </a:extLst>
            </p:cNvPr>
            <p:cNvSpPr txBox="1"/>
            <p:nvPr/>
          </p:nvSpPr>
          <p:spPr>
            <a:xfrm rot="18413975">
              <a:off x="2135082" y="11031983"/>
              <a:ext cx="704467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C846CF86-B0AC-D04B-BB68-177E227D4E82}"/>
                </a:ext>
              </a:extLst>
            </p:cNvPr>
            <p:cNvSpPr txBox="1"/>
            <p:nvPr/>
          </p:nvSpPr>
          <p:spPr>
            <a:xfrm rot="18413975">
              <a:off x="2408743" y="11003478"/>
              <a:ext cx="66172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DCD9A0D1-2020-4742-AC8B-033BE93AB56C}"/>
                </a:ext>
              </a:extLst>
            </p:cNvPr>
            <p:cNvSpPr txBox="1"/>
            <p:nvPr/>
          </p:nvSpPr>
          <p:spPr>
            <a:xfrm rot="18413975">
              <a:off x="2810759" y="11039503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0A8384DE-5D16-B540-A44D-347D8584FBFB}"/>
                </a:ext>
              </a:extLst>
            </p:cNvPr>
            <p:cNvSpPr txBox="1"/>
            <p:nvPr/>
          </p:nvSpPr>
          <p:spPr>
            <a:xfrm rot="18413975">
              <a:off x="3251002" y="10960304"/>
              <a:ext cx="54203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A4CAD8DE-995A-E546-B7A4-5E11A03D65ED}"/>
                </a:ext>
              </a:extLst>
            </p:cNvPr>
            <p:cNvSpPr txBox="1"/>
            <p:nvPr/>
          </p:nvSpPr>
          <p:spPr>
            <a:xfrm rot="18413975">
              <a:off x="3299363" y="11037364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610BB61D-D88B-094B-B13B-D82E2FB4FA10}"/>
                </a:ext>
              </a:extLst>
            </p:cNvPr>
            <p:cNvSpPr txBox="1"/>
            <p:nvPr/>
          </p:nvSpPr>
          <p:spPr>
            <a:xfrm rot="18413975">
              <a:off x="2585056" y="11060921"/>
              <a:ext cx="77286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5" name="Rectangle 54">
            <a:extLst>
              <a:ext uri="{FF2B5EF4-FFF2-40B4-BE49-F238E27FC236}">
                <a16:creationId xmlns:a16="http://schemas.microsoft.com/office/drawing/2014/main" id="{ACC3FD3F-70F6-C04B-8B01-BBF6D7A2E0EB}"/>
              </a:ext>
            </a:extLst>
          </p:cNvPr>
          <p:cNvSpPr/>
          <p:nvPr/>
        </p:nvSpPr>
        <p:spPr>
          <a:xfrm>
            <a:off x="4561608" y="2335686"/>
            <a:ext cx="3707754" cy="2777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grpSp>
        <p:nvGrpSpPr>
          <p:cNvPr id="56" name="Group 55">
            <a:extLst>
              <a:ext uri="{FF2B5EF4-FFF2-40B4-BE49-F238E27FC236}">
                <a16:creationId xmlns:a16="http://schemas.microsoft.com/office/drawing/2014/main" id="{D063F476-9164-A74D-9300-C6BB3B295E4D}"/>
              </a:ext>
            </a:extLst>
          </p:cNvPr>
          <p:cNvGrpSpPr/>
          <p:nvPr/>
        </p:nvGrpSpPr>
        <p:grpSpPr>
          <a:xfrm>
            <a:off x="4662731" y="994915"/>
            <a:ext cx="1008665" cy="450390"/>
            <a:chOff x="2071294" y="10821065"/>
            <a:chExt cx="1793182" cy="800693"/>
          </a:xfrm>
        </p:grpSpPr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CC809D6-0C19-434C-8631-B7295D983AA9}"/>
                </a:ext>
              </a:extLst>
            </p:cNvPr>
            <p:cNvSpPr txBox="1"/>
            <p:nvPr/>
          </p:nvSpPr>
          <p:spPr>
            <a:xfrm rot="18413975">
              <a:off x="1897741" y="11035185"/>
              <a:ext cx="695919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24344A6-1432-0C4C-A33F-326D410C18FD}"/>
                </a:ext>
              </a:extLst>
            </p:cNvPr>
            <p:cNvSpPr txBox="1"/>
            <p:nvPr/>
          </p:nvSpPr>
          <p:spPr>
            <a:xfrm rot="18413975">
              <a:off x="2135082" y="11031983"/>
              <a:ext cx="704467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EEB9F65B-9D07-1848-B5AD-498A29859F9C}"/>
                </a:ext>
              </a:extLst>
            </p:cNvPr>
            <p:cNvSpPr txBox="1"/>
            <p:nvPr/>
          </p:nvSpPr>
          <p:spPr>
            <a:xfrm rot="18413975">
              <a:off x="2408743" y="11003478"/>
              <a:ext cx="66172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C83D05CD-6F46-4044-99C1-2639374B2352}"/>
                </a:ext>
              </a:extLst>
            </p:cNvPr>
            <p:cNvSpPr txBox="1"/>
            <p:nvPr/>
          </p:nvSpPr>
          <p:spPr>
            <a:xfrm rot="18413975">
              <a:off x="2810759" y="11039503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A0A6655-D762-474F-969D-BE03839422AE}"/>
                </a:ext>
              </a:extLst>
            </p:cNvPr>
            <p:cNvSpPr txBox="1"/>
            <p:nvPr/>
          </p:nvSpPr>
          <p:spPr>
            <a:xfrm rot="18413975">
              <a:off x="3251002" y="10960304"/>
              <a:ext cx="54203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371CCAE5-5031-824B-A494-AE983533BEB8}"/>
                </a:ext>
              </a:extLst>
            </p:cNvPr>
            <p:cNvSpPr txBox="1"/>
            <p:nvPr/>
          </p:nvSpPr>
          <p:spPr>
            <a:xfrm rot="18413975">
              <a:off x="3299363" y="11037364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B65203B1-C7D5-854C-80BD-2602470DB4E9}"/>
                </a:ext>
              </a:extLst>
            </p:cNvPr>
            <p:cNvSpPr txBox="1"/>
            <p:nvPr/>
          </p:nvSpPr>
          <p:spPr>
            <a:xfrm rot="18413975">
              <a:off x="2585056" y="11060921"/>
              <a:ext cx="77286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D95C4D5A-75D9-5E42-94C6-2C31BED73265}"/>
              </a:ext>
            </a:extLst>
          </p:cNvPr>
          <p:cNvGrpSpPr/>
          <p:nvPr/>
        </p:nvGrpSpPr>
        <p:grpSpPr>
          <a:xfrm>
            <a:off x="5903559" y="2230148"/>
            <a:ext cx="1008665" cy="450390"/>
            <a:chOff x="2071294" y="10821065"/>
            <a:chExt cx="1793182" cy="800693"/>
          </a:xfrm>
        </p:grpSpPr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530847B-A2EF-0044-A50C-606B972D405C}"/>
                </a:ext>
              </a:extLst>
            </p:cNvPr>
            <p:cNvSpPr txBox="1"/>
            <p:nvPr/>
          </p:nvSpPr>
          <p:spPr>
            <a:xfrm rot="18413975">
              <a:off x="1897741" y="11035185"/>
              <a:ext cx="695919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8C4E4C98-CFB6-3D42-8A0A-E01274552779}"/>
                </a:ext>
              </a:extLst>
            </p:cNvPr>
            <p:cNvSpPr txBox="1"/>
            <p:nvPr/>
          </p:nvSpPr>
          <p:spPr>
            <a:xfrm rot="18413975">
              <a:off x="2135082" y="11031983"/>
              <a:ext cx="704467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1BBD228D-D526-DE49-97E7-4F173D1A198F}"/>
                </a:ext>
              </a:extLst>
            </p:cNvPr>
            <p:cNvSpPr txBox="1"/>
            <p:nvPr/>
          </p:nvSpPr>
          <p:spPr>
            <a:xfrm rot="18413975">
              <a:off x="2408743" y="11003478"/>
              <a:ext cx="66172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2D536FBC-DF38-904E-AC74-27FE7129DD4C}"/>
                </a:ext>
              </a:extLst>
            </p:cNvPr>
            <p:cNvSpPr txBox="1"/>
            <p:nvPr/>
          </p:nvSpPr>
          <p:spPr>
            <a:xfrm rot="18413975">
              <a:off x="2810759" y="11039503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E19CD5F3-A9C1-4D49-AB19-5D0974202B78}"/>
                </a:ext>
              </a:extLst>
            </p:cNvPr>
            <p:cNvSpPr txBox="1"/>
            <p:nvPr/>
          </p:nvSpPr>
          <p:spPr>
            <a:xfrm rot="18413975">
              <a:off x="3251002" y="10960304"/>
              <a:ext cx="54203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6769A6CD-1E09-9544-85CF-4C90727AA646}"/>
                </a:ext>
              </a:extLst>
            </p:cNvPr>
            <p:cNvSpPr txBox="1"/>
            <p:nvPr/>
          </p:nvSpPr>
          <p:spPr>
            <a:xfrm rot="18413975">
              <a:off x="3299363" y="11037364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21A0C99F-E230-8A47-B766-25E66435C792}"/>
                </a:ext>
              </a:extLst>
            </p:cNvPr>
            <p:cNvSpPr txBox="1"/>
            <p:nvPr/>
          </p:nvSpPr>
          <p:spPr>
            <a:xfrm rot="18413975">
              <a:off x="2585056" y="11060921"/>
              <a:ext cx="77286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DDBCF4E7-239D-DF40-88E4-6AE61916FFC0}"/>
              </a:ext>
            </a:extLst>
          </p:cNvPr>
          <p:cNvGrpSpPr/>
          <p:nvPr/>
        </p:nvGrpSpPr>
        <p:grpSpPr>
          <a:xfrm>
            <a:off x="7155060" y="2224980"/>
            <a:ext cx="1008665" cy="450390"/>
            <a:chOff x="2071294" y="10821065"/>
            <a:chExt cx="1793182" cy="800693"/>
          </a:xfrm>
        </p:grpSpPr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234A1A18-D2DC-9E4D-9FF6-0AFC69C9A0F6}"/>
                </a:ext>
              </a:extLst>
            </p:cNvPr>
            <p:cNvSpPr txBox="1"/>
            <p:nvPr/>
          </p:nvSpPr>
          <p:spPr>
            <a:xfrm rot="18413975">
              <a:off x="1897741" y="11035185"/>
              <a:ext cx="695919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3DB31B7D-3A40-F34A-98C7-2639302E3682}"/>
                </a:ext>
              </a:extLst>
            </p:cNvPr>
            <p:cNvSpPr txBox="1"/>
            <p:nvPr/>
          </p:nvSpPr>
          <p:spPr>
            <a:xfrm rot="18413975">
              <a:off x="2135082" y="11031983"/>
              <a:ext cx="704467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DD3522F9-ABED-C64B-A9C4-25972114AE02}"/>
                </a:ext>
              </a:extLst>
            </p:cNvPr>
            <p:cNvSpPr txBox="1"/>
            <p:nvPr/>
          </p:nvSpPr>
          <p:spPr>
            <a:xfrm rot="18413975">
              <a:off x="2408743" y="11003478"/>
              <a:ext cx="66172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B89E8F33-5ABE-B94D-B93E-F0E32039239D}"/>
                </a:ext>
              </a:extLst>
            </p:cNvPr>
            <p:cNvSpPr txBox="1"/>
            <p:nvPr/>
          </p:nvSpPr>
          <p:spPr>
            <a:xfrm rot="18413975">
              <a:off x="2810759" y="11039503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F34E6FFC-8DCF-A140-B46C-4FAA5EF716CC}"/>
                </a:ext>
              </a:extLst>
            </p:cNvPr>
            <p:cNvSpPr txBox="1"/>
            <p:nvPr/>
          </p:nvSpPr>
          <p:spPr>
            <a:xfrm rot="18413975">
              <a:off x="3251002" y="10960304"/>
              <a:ext cx="54203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49F8D8E5-4323-994A-B2FF-94032F75F2B0}"/>
                </a:ext>
              </a:extLst>
            </p:cNvPr>
            <p:cNvSpPr txBox="1"/>
            <p:nvPr/>
          </p:nvSpPr>
          <p:spPr>
            <a:xfrm rot="18413975">
              <a:off x="3299363" y="11037364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52F13D94-0F7F-E740-995D-80D951F6D6BF}"/>
                </a:ext>
              </a:extLst>
            </p:cNvPr>
            <p:cNvSpPr txBox="1"/>
            <p:nvPr/>
          </p:nvSpPr>
          <p:spPr>
            <a:xfrm rot="18413975">
              <a:off x="2585056" y="11060921"/>
              <a:ext cx="77286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0" name="Rectangle 79">
            <a:extLst>
              <a:ext uri="{FF2B5EF4-FFF2-40B4-BE49-F238E27FC236}">
                <a16:creationId xmlns:a16="http://schemas.microsoft.com/office/drawing/2014/main" id="{168521DB-AC6A-0F4E-A583-96DD40AEB5D2}"/>
              </a:ext>
            </a:extLst>
          </p:cNvPr>
          <p:cNvSpPr/>
          <p:nvPr/>
        </p:nvSpPr>
        <p:spPr>
          <a:xfrm>
            <a:off x="4527687" y="3639986"/>
            <a:ext cx="3707754" cy="2777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grpSp>
        <p:nvGrpSpPr>
          <p:cNvPr id="81" name="Group 80">
            <a:extLst>
              <a:ext uri="{FF2B5EF4-FFF2-40B4-BE49-F238E27FC236}">
                <a16:creationId xmlns:a16="http://schemas.microsoft.com/office/drawing/2014/main" id="{A9952E1B-69C8-E249-B3C1-0D0646388DA0}"/>
              </a:ext>
            </a:extLst>
          </p:cNvPr>
          <p:cNvGrpSpPr/>
          <p:nvPr/>
        </p:nvGrpSpPr>
        <p:grpSpPr>
          <a:xfrm>
            <a:off x="4646965" y="2224722"/>
            <a:ext cx="1008665" cy="450390"/>
            <a:chOff x="2071294" y="10821065"/>
            <a:chExt cx="1793182" cy="800693"/>
          </a:xfrm>
        </p:grpSpPr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98E0A01E-40A3-744C-868A-5D34CDC0AADC}"/>
                </a:ext>
              </a:extLst>
            </p:cNvPr>
            <p:cNvSpPr txBox="1"/>
            <p:nvPr/>
          </p:nvSpPr>
          <p:spPr>
            <a:xfrm rot="18413975">
              <a:off x="1897741" y="11035185"/>
              <a:ext cx="695919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D05293F9-7F10-6C41-84DD-9A603D264975}"/>
                </a:ext>
              </a:extLst>
            </p:cNvPr>
            <p:cNvSpPr txBox="1"/>
            <p:nvPr/>
          </p:nvSpPr>
          <p:spPr>
            <a:xfrm rot="18413975">
              <a:off x="2135082" y="11031983"/>
              <a:ext cx="704467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F7DFF441-F28B-9A43-A21A-2B462FC015A2}"/>
                </a:ext>
              </a:extLst>
            </p:cNvPr>
            <p:cNvSpPr txBox="1"/>
            <p:nvPr/>
          </p:nvSpPr>
          <p:spPr>
            <a:xfrm rot="18413975">
              <a:off x="2408743" y="11003478"/>
              <a:ext cx="66172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AD79F7AD-739F-2840-A593-CD2DCCE8FA84}"/>
                </a:ext>
              </a:extLst>
            </p:cNvPr>
            <p:cNvSpPr txBox="1"/>
            <p:nvPr/>
          </p:nvSpPr>
          <p:spPr>
            <a:xfrm rot="18413975">
              <a:off x="2810759" y="11039503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B221B2C4-B0E8-2142-95A8-3B62C916092A}"/>
                </a:ext>
              </a:extLst>
            </p:cNvPr>
            <p:cNvSpPr txBox="1"/>
            <p:nvPr/>
          </p:nvSpPr>
          <p:spPr>
            <a:xfrm rot="18413975">
              <a:off x="3251002" y="10960304"/>
              <a:ext cx="54203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0E91BBA6-EF35-1440-BC59-A0DFF83630A9}"/>
                </a:ext>
              </a:extLst>
            </p:cNvPr>
            <p:cNvSpPr txBox="1"/>
            <p:nvPr/>
          </p:nvSpPr>
          <p:spPr>
            <a:xfrm rot="18413975">
              <a:off x="3299363" y="11037364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87B12A76-0E53-7549-A8F6-7E87047EA5A2}"/>
                </a:ext>
              </a:extLst>
            </p:cNvPr>
            <p:cNvSpPr txBox="1"/>
            <p:nvPr/>
          </p:nvSpPr>
          <p:spPr>
            <a:xfrm rot="18413975">
              <a:off x="2585056" y="11060921"/>
              <a:ext cx="77286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9" name="Group 88">
            <a:extLst>
              <a:ext uri="{FF2B5EF4-FFF2-40B4-BE49-F238E27FC236}">
                <a16:creationId xmlns:a16="http://schemas.microsoft.com/office/drawing/2014/main" id="{ECBB877B-C3B2-304D-9B2E-422F3FA14543}"/>
              </a:ext>
            </a:extLst>
          </p:cNvPr>
          <p:cNvGrpSpPr/>
          <p:nvPr/>
        </p:nvGrpSpPr>
        <p:grpSpPr>
          <a:xfrm>
            <a:off x="5885065" y="3543838"/>
            <a:ext cx="1008665" cy="450390"/>
            <a:chOff x="2071294" y="10821065"/>
            <a:chExt cx="1793182" cy="800693"/>
          </a:xfrm>
        </p:grpSpPr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784A0E7B-DC74-8944-8485-798E35FBF976}"/>
                </a:ext>
              </a:extLst>
            </p:cNvPr>
            <p:cNvSpPr txBox="1"/>
            <p:nvPr/>
          </p:nvSpPr>
          <p:spPr>
            <a:xfrm rot="18413975">
              <a:off x="1897741" y="11035185"/>
              <a:ext cx="695919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93B99642-0651-2740-8DE6-B4F9C8DE16C8}"/>
                </a:ext>
              </a:extLst>
            </p:cNvPr>
            <p:cNvSpPr txBox="1"/>
            <p:nvPr/>
          </p:nvSpPr>
          <p:spPr>
            <a:xfrm rot="18413975">
              <a:off x="2135082" y="11031983"/>
              <a:ext cx="704467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0B8B9C6E-5CCB-AE4C-A511-2B62C160798C}"/>
                </a:ext>
              </a:extLst>
            </p:cNvPr>
            <p:cNvSpPr txBox="1"/>
            <p:nvPr/>
          </p:nvSpPr>
          <p:spPr>
            <a:xfrm rot="18413975">
              <a:off x="2408743" y="11003478"/>
              <a:ext cx="66172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B7DC86E1-ABB7-A444-AE0E-122E28FFE2C0}"/>
                </a:ext>
              </a:extLst>
            </p:cNvPr>
            <p:cNvSpPr txBox="1"/>
            <p:nvPr/>
          </p:nvSpPr>
          <p:spPr>
            <a:xfrm rot="18413975">
              <a:off x="2810759" y="11039503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9086BA71-E398-FE4D-A780-9844BF264889}"/>
                </a:ext>
              </a:extLst>
            </p:cNvPr>
            <p:cNvSpPr txBox="1"/>
            <p:nvPr/>
          </p:nvSpPr>
          <p:spPr>
            <a:xfrm rot="18413975">
              <a:off x="3251002" y="10960304"/>
              <a:ext cx="54203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751EDE30-069A-2346-9151-EFBF639ED6F0}"/>
                </a:ext>
              </a:extLst>
            </p:cNvPr>
            <p:cNvSpPr txBox="1"/>
            <p:nvPr/>
          </p:nvSpPr>
          <p:spPr>
            <a:xfrm rot="18413975">
              <a:off x="3299363" y="11037364"/>
              <a:ext cx="781411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7D69E282-7962-A94D-B21F-37DBACECD128}"/>
                </a:ext>
              </a:extLst>
            </p:cNvPr>
            <p:cNvSpPr txBox="1"/>
            <p:nvPr/>
          </p:nvSpPr>
          <p:spPr>
            <a:xfrm rot="18413975">
              <a:off x="2585056" y="11060921"/>
              <a:ext cx="772860" cy="348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7" name="Group 96">
            <a:extLst>
              <a:ext uri="{FF2B5EF4-FFF2-40B4-BE49-F238E27FC236}">
                <a16:creationId xmlns:a16="http://schemas.microsoft.com/office/drawing/2014/main" id="{847B4A84-47E6-D642-AC92-5882D67F562F}"/>
              </a:ext>
            </a:extLst>
          </p:cNvPr>
          <p:cNvGrpSpPr/>
          <p:nvPr/>
        </p:nvGrpSpPr>
        <p:grpSpPr>
          <a:xfrm>
            <a:off x="7214220" y="3534668"/>
            <a:ext cx="1057921" cy="450390"/>
            <a:chOff x="2081264" y="10821065"/>
            <a:chExt cx="1773243" cy="800694"/>
          </a:xfrm>
        </p:grpSpPr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C2340A4F-E35A-0D40-B05B-E99232AAADB8}"/>
                </a:ext>
              </a:extLst>
            </p:cNvPr>
            <p:cNvSpPr txBox="1"/>
            <p:nvPr/>
          </p:nvSpPr>
          <p:spPr>
            <a:xfrm rot="18413975">
              <a:off x="1897742" y="11045156"/>
              <a:ext cx="695919" cy="3288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023712DF-A6F3-394B-AE8C-42C46D02DB83}"/>
                </a:ext>
              </a:extLst>
            </p:cNvPr>
            <p:cNvSpPr txBox="1"/>
            <p:nvPr/>
          </p:nvSpPr>
          <p:spPr>
            <a:xfrm rot="18413975">
              <a:off x="2135082" y="11041952"/>
              <a:ext cx="704467" cy="3288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C6F8A213-5401-564A-8FEF-181790A70B9D}"/>
                </a:ext>
              </a:extLst>
            </p:cNvPr>
            <p:cNvSpPr txBox="1"/>
            <p:nvPr/>
          </p:nvSpPr>
          <p:spPr>
            <a:xfrm rot="18413975">
              <a:off x="2408744" y="11013448"/>
              <a:ext cx="661720" cy="3288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59ED27B7-05E0-AB46-9254-EF25B1759563}"/>
                </a:ext>
              </a:extLst>
            </p:cNvPr>
            <p:cNvSpPr txBox="1"/>
            <p:nvPr/>
          </p:nvSpPr>
          <p:spPr>
            <a:xfrm rot="18413975">
              <a:off x="2810759" y="11049472"/>
              <a:ext cx="781412" cy="3288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5118B171-CF2F-DE4F-8AD4-F6C6B416CBA5}"/>
                </a:ext>
              </a:extLst>
            </p:cNvPr>
            <p:cNvSpPr txBox="1"/>
            <p:nvPr/>
          </p:nvSpPr>
          <p:spPr>
            <a:xfrm rot="18413975">
              <a:off x="3251003" y="10970274"/>
              <a:ext cx="542031" cy="3288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9022C606-5248-2040-9F30-8F66E75BD435}"/>
                </a:ext>
              </a:extLst>
            </p:cNvPr>
            <p:cNvSpPr txBox="1"/>
            <p:nvPr/>
          </p:nvSpPr>
          <p:spPr>
            <a:xfrm rot="18413975">
              <a:off x="3299363" y="11047333"/>
              <a:ext cx="781412" cy="3288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7EBEACE4-DF09-B249-BCBE-7B6F3601CE06}"/>
                </a:ext>
              </a:extLst>
            </p:cNvPr>
            <p:cNvSpPr txBox="1"/>
            <p:nvPr/>
          </p:nvSpPr>
          <p:spPr>
            <a:xfrm rot="18413975">
              <a:off x="2585054" y="11070891"/>
              <a:ext cx="772861" cy="3288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5" name="Rectangle 104">
            <a:extLst>
              <a:ext uri="{FF2B5EF4-FFF2-40B4-BE49-F238E27FC236}">
                <a16:creationId xmlns:a16="http://schemas.microsoft.com/office/drawing/2014/main" id="{4318E76A-31BD-8D45-BBB1-9078F4413BE8}"/>
              </a:ext>
            </a:extLst>
          </p:cNvPr>
          <p:cNvSpPr/>
          <p:nvPr/>
        </p:nvSpPr>
        <p:spPr>
          <a:xfrm>
            <a:off x="4550131" y="4965905"/>
            <a:ext cx="3707754" cy="2777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grpSp>
        <p:nvGrpSpPr>
          <p:cNvPr id="106" name="Group 105">
            <a:extLst>
              <a:ext uri="{FF2B5EF4-FFF2-40B4-BE49-F238E27FC236}">
                <a16:creationId xmlns:a16="http://schemas.microsoft.com/office/drawing/2014/main" id="{2774298F-D3DD-A747-A040-D53392284532}"/>
              </a:ext>
            </a:extLst>
          </p:cNvPr>
          <p:cNvGrpSpPr/>
          <p:nvPr/>
        </p:nvGrpSpPr>
        <p:grpSpPr>
          <a:xfrm>
            <a:off x="4624959" y="3514278"/>
            <a:ext cx="1044722" cy="450391"/>
            <a:chOff x="2078705" y="10821065"/>
            <a:chExt cx="1778360" cy="800695"/>
          </a:xfrm>
        </p:grpSpPr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7D8FD4C3-AC66-B043-B4C8-8D16B4542F40}"/>
                </a:ext>
              </a:extLst>
            </p:cNvPr>
            <p:cNvSpPr txBox="1"/>
            <p:nvPr/>
          </p:nvSpPr>
          <p:spPr>
            <a:xfrm rot="18413975">
              <a:off x="1897741" y="11042597"/>
              <a:ext cx="695919" cy="333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>
              <a:extLst>
                <a:ext uri="{FF2B5EF4-FFF2-40B4-BE49-F238E27FC236}">
                  <a16:creationId xmlns:a16="http://schemas.microsoft.com/office/drawing/2014/main" id="{AFDAF66E-DA91-DC4F-897E-E92C39E9CCF6}"/>
                </a:ext>
              </a:extLst>
            </p:cNvPr>
            <p:cNvSpPr txBox="1"/>
            <p:nvPr/>
          </p:nvSpPr>
          <p:spPr>
            <a:xfrm rot="18413975">
              <a:off x="2135082" y="11039393"/>
              <a:ext cx="704467" cy="333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C8358B78-527A-6E46-8F3D-1A6FE2FB5BB3}"/>
                </a:ext>
              </a:extLst>
            </p:cNvPr>
            <p:cNvSpPr txBox="1"/>
            <p:nvPr/>
          </p:nvSpPr>
          <p:spPr>
            <a:xfrm rot="18413975">
              <a:off x="2408743" y="11010889"/>
              <a:ext cx="661720" cy="333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AE72AC61-1CE0-3D4D-827F-D7ABD7646AEC}"/>
                </a:ext>
              </a:extLst>
            </p:cNvPr>
            <p:cNvSpPr txBox="1"/>
            <p:nvPr/>
          </p:nvSpPr>
          <p:spPr>
            <a:xfrm rot="18413975">
              <a:off x="2810759" y="11046915"/>
              <a:ext cx="781412" cy="333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7D905642-7DE9-5B45-9FAB-D6240EF78CC3}"/>
                </a:ext>
              </a:extLst>
            </p:cNvPr>
            <p:cNvSpPr txBox="1"/>
            <p:nvPr/>
          </p:nvSpPr>
          <p:spPr>
            <a:xfrm rot="18413975">
              <a:off x="3251002" y="10967715"/>
              <a:ext cx="542031" cy="333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BE0E7F63-F452-0F46-A276-FC35F8BA0E79}"/>
                </a:ext>
              </a:extLst>
            </p:cNvPr>
            <p:cNvSpPr txBox="1"/>
            <p:nvPr/>
          </p:nvSpPr>
          <p:spPr>
            <a:xfrm rot="18413975">
              <a:off x="3299363" y="11044775"/>
              <a:ext cx="781412" cy="333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2152221B-133C-3148-A80D-E2F5F5B54499}"/>
                </a:ext>
              </a:extLst>
            </p:cNvPr>
            <p:cNvSpPr txBox="1"/>
            <p:nvPr/>
          </p:nvSpPr>
          <p:spPr>
            <a:xfrm rot="18413975">
              <a:off x="2585055" y="11068334"/>
              <a:ext cx="772860" cy="333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4BD92065-A60E-2F4A-981B-CC85ED9FBE0D}"/>
              </a:ext>
            </a:extLst>
          </p:cNvPr>
          <p:cNvGrpSpPr/>
          <p:nvPr/>
        </p:nvGrpSpPr>
        <p:grpSpPr>
          <a:xfrm>
            <a:off x="4682988" y="4873231"/>
            <a:ext cx="1084962" cy="450390"/>
            <a:chOff x="2086266" y="10821066"/>
            <a:chExt cx="1763237" cy="800693"/>
          </a:xfrm>
        </p:grpSpPr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1FC7588F-483B-AA43-85D4-72A056EB6154}"/>
                </a:ext>
              </a:extLst>
            </p:cNvPr>
            <p:cNvSpPr txBox="1"/>
            <p:nvPr/>
          </p:nvSpPr>
          <p:spPr>
            <a:xfrm rot="18413975">
              <a:off x="1897741" y="11050159"/>
              <a:ext cx="695919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8643E3CF-55CD-C94F-A3BC-267217D4CC9B}"/>
                </a:ext>
              </a:extLst>
            </p:cNvPr>
            <p:cNvSpPr txBox="1"/>
            <p:nvPr/>
          </p:nvSpPr>
          <p:spPr>
            <a:xfrm rot="18413975">
              <a:off x="2135083" y="11046955"/>
              <a:ext cx="704467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BE5A6D92-7805-F64E-B9A3-99877635739D}"/>
                </a:ext>
              </a:extLst>
            </p:cNvPr>
            <p:cNvSpPr txBox="1"/>
            <p:nvPr/>
          </p:nvSpPr>
          <p:spPr>
            <a:xfrm rot="18413975">
              <a:off x="2408744" y="11018451"/>
              <a:ext cx="661720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9D9B4915-C49D-0342-943C-6EFC77F188A4}"/>
                </a:ext>
              </a:extLst>
            </p:cNvPr>
            <p:cNvSpPr txBox="1"/>
            <p:nvPr/>
          </p:nvSpPr>
          <p:spPr>
            <a:xfrm rot="18413975">
              <a:off x="2810759" y="11054477"/>
              <a:ext cx="781412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>
              <a:extLst>
                <a:ext uri="{FF2B5EF4-FFF2-40B4-BE49-F238E27FC236}">
                  <a16:creationId xmlns:a16="http://schemas.microsoft.com/office/drawing/2014/main" id="{2542E613-CD10-CC4D-ABB3-0327F1D3682B}"/>
                </a:ext>
              </a:extLst>
            </p:cNvPr>
            <p:cNvSpPr txBox="1"/>
            <p:nvPr/>
          </p:nvSpPr>
          <p:spPr>
            <a:xfrm rot="18413975">
              <a:off x="3251002" y="10975277"/>
              <a:ext cx="542031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F89E4F51-6785-9D4A-BCF8-FA4633C00F51}"/>
                </a:ext>
              </a:extLst>
            </p:cNvPr>
            <p:cNvSpPr txBox="1"/>
            <p:nvPr/>
          </p:nvSpPr>
          <p:spPr>
            <a:xfrm rot="18413975">
              <a:off x="3299363" y="11052337"/>
              <a:ext cx="781412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FEFF2254-E3C3-D048-9A68-EDA24CAC2033}"/>
                </a:ext>
              </a:extLst>
            </p:cNvPr>
            <p:cNvSpPr txBox="1"/>
            <p:nvPr/>
          </p:nvSpPr>
          <p:spPr>
            <a:xfrm rot="18413975">
              <a:off x="2585056" y="11075894"/>
              <a:ext cx="772860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7E26358E-274F-7249-81CA-7BE923597056}"/>
              </a:ext>
            </a:extLst>
          </p:cNvPr>
          <p:cNvGrpSpPr/>
          <p:nvPr/>
        </p:nvGrpSpPr>
        <p:grpSpPr>
          <a:xfrm>
            <a:off x="5940917" y="4869161"/>
            <a:ext cx="1084962" cy="450390"/>
            <a:chOff x="2086266" y="10821066"/>
            <a:chExt cx="1763237" cy="800693"/>
          </a:xfrm>
        </p:grpSpPr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9B171F67-2BF3-DD4E-BA9A-21C5E20CACDF}"/>
                </a:ext>
              </a:extLst>
            </p:cNvPr>
            <p:cNvSpPr txBox="1"/>
            <p:nvPr/>
          </p:nvSpPr>
          <p:spPr>
            <a:xfrm rot="18413975">
              <a:off x="1897741" y="11050159"/>
              <a:ext cx="695919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F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>
              <a:extLst>
                <a:ext uri="{FF2B5EF4-FFF2-40B4-BE49-F238E27FC236}">
                  <a16:creationId xmlns:a16="http://schemas.microsoft.com/office/drawing/2014/main" id="{D72834DB-7038-624A-8F4D-68F99B725919}"/>
                </a:ext>
              </a:extLst>
            </p:cNvPr>
            <p:cNvSpPr txBox="1"/>
            <p:nvPr/>
          </p:nvSpPr>
          <p:spPr>
            <a:xfrm rot="18413975">
              <a:off x="2135083" y="11046955"/>
              <a:ext cx="704467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A-</a:t>
              </a:r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Ast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>
              <a:extLst>
                <a:ext uri="{FF2B5EF4-FFF2-40B4-BE49-F238E27FC236}">
                  <a16:creationId xmlns:a16="http://schemas.microsoft.com/office/drawing/2014/main" id="{B7444887-FABA-1243-89AB-FAC603673311}"/>
                </a:ext>
              </a:extLst>
            </p:cNvPr>
            <p:cNvSpPr txBox="1"/>
            <p:nvPr/>
          </p:nvSpPr>
          <p:spPr>
            <a:xfrm rot="18413975">
              <a:off x="2408744" y="11018451"/>
              <a:ext cx="661720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Nron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616BC03E-80FA-6644-968B-1EBEDA10AA96}"/>
                </a:ext>
              </a:extLst>
            </p:cNvPr>
            <p:cNvSpPr txBox="1"/>
            <p:nvPr/>
          </p:nvSpPr>
          <p:spPr>
            <a:xfrm rot="18413975">
              <a:off x="2810759" y="11054477"/>
              <a:ext cx="781412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MiMac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254F83D2-E6DD-ED48-AD2C-67B9BD64774D}"/>
                </a:ext>
              </a:extLst>
            </p:cNvPr>
            <p:cNvSpPr txBox="1"/>
            <p:nvPr/>
          </p:nvSpPr>
          <p:spPr>
            <a:xfrm rot="18413975">
              <a:off x="3251002" y="10975277"/>
              <a:ext cx="542031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EC</a:t>
              </a:r>
            </a:p>
          </p:txBody>
        </p:sp>
        <p:sp>
          <p:nvSpPr>
            <p:cNvPr id="128" name="TextBox 127">
              <a:extLst>
                <a:ext uri="{FF2B5EF4-FFF2-40B4-BE49-F238E27FC236}">
                  <a16:creationId xmlns:a16="http://schemas.microsoft.com/office/drawing/2014/main" id="{4C750172-47E5-3148-8DFA-58C58097341E}"/>
                </a:ext>
              </a:extLst>
            </p:cNvPr>
            <p:cNvSpPr txBox="1"/>
            <p:nvPr/>
          </p:nvSpPr>
          <p:spPr>
            <a:xfrm rot="18413975">
              <a:off x="3299363" y="11052337"/>
              <a:ext cx="781412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>
                  <a:latin typeface="Arial" panose="020B0604020202020204" pitchFamily="34" charset="0"/>
                  <a:cs typeface="Arial" panose="020B0604020202020204" pitchFamily="34" charset="0"/>
                </a:rPr>
                <a:t>Cortex</a:t>
              </a:r>
            </a:p>
          </p:txBody>
        </p: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2B98110A-789E-E54F-BB42-0AC7D28B5CF4}"/>
                </a:ext>
              </a:extLst>
            </p:cNvPr>
            <p:cNvSpPr txBox="1"/>
            <p:nvPr/>
          </p:nvSpPr>
          <p:spPr>
            <a:xfrm rot="18413975">
              <a:off x="2585056" y="11075894"/>
              <a:ext cx="772860" cy="3188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75" dirty="0" err="1">
                  <a:latin typeface="Arial" panose="020B0604020202020204" pitchFamily="34" charset="0"/>
                  <a:cs typeface="Arial" panose="020B0604020202020204" pitchFamily="34" charset="0"/>
                </a:rPr>
                <a:t>Oligod</a:t>
              </a:r>
              <a:endParaRPr lang="en-US" sz="675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0" name="Group 129">
            <a:extLst>
              <a:ext uri="{FF2B5EF4-FFF2-40B4-BE49-F238E27FC236}">
                <a16:creationId xmlns:a16="http://schemas.microsoft.com/office/drawing/2014/main" id="{4059C41C-B883-7648-9D1F-2D90274B6DF0}"/>
              </a:ext>
            </a:extLst>
          </p:cNvPr>
          <p:cNvGrpSpPr/>
          <p:nvPr/>
        </p:nvGrpSpPr>
        <p:grpSpPr>
          <a:xfrm>
            <a:off x="227621" y="160595"/>
            <a:ext cx="4093204" cy="6396592"/>
            <a:chOff x="8127134" y="344261"/>
            <a:chExt cx="4093204" cy="6396592"/>
          </a:xfrm>
        </p:grpSpPr>
        <p:pic>
          <p:nvPicPr>
            <p:cNvPr id="131" name="Picture 130">
              <a:extLst>
                <a:ext uri="{FF2B5EF4-FFF2-40B4-BE49-F238E27FC236}">
                  <a16:creationId xmlns:a16="http://schemas.microsoft.com/office/drawing/2014/main" id="{C8276233-053F-694B-83DA-C106484EDBA3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8370998" y="344261"/>
              <a:ext cx="3828000" cy="6255745"/>
            </a:xfrm>
            <a:prstGeom prst="rect">
              <a:avLst/>
            </a:prstGeom>
          </p:spPr>
        </p:pic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2F3073FC-CA3A-2B45-8779-76F5D2309AA1}"/>
                </a:ext>
              </a:extLst>
            </p:cNvPr>
            <p:cNvSpPr txBox="1"/>
            <p:nvPr/>
          </p:nvSpPr>
          <p:spPr>
            <a:xfrm>
              <a:off x="8542303" y="467740"/>
              <a:ext cx="69281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TPRC****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B7ED23F2-B070-BF4C-A234-D1877025A4E0}"/>
                </a:ext>
              </a:extLst>
            </p:cNvPr>
            <p:cNvSpPr txBox="1"/>
            <p:nvPr/>
          </p:nvSpPr>
          <p:spPr>
            <a:xfrm>
              <a:off x="9812461" y="467739"/>
              <a:ext cx="60144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AVCR2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13ED3395-F7BC-7846-B31F-FA2AE26B7F50}"/>
                </a:ext>
              </a:extLst>
            </p:cNvPr>
            <p:cNvSpPr txBox="1"/>
            <p:nvPr/>
          </p:nvSpPr>
          <p:spPr>
            <a:xfrm>
              <a:off x="11070572" y="467739"/>
              <a:ext cx="69602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GALS9***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901A1B00-EC1D-6F4F-8C97-1BBC3360B509}"/>
                </a:ext>
              </a:extLst>
            </p:cNvPr>
            <p:cNvSpPr txBox="1"/>
            <p:nvPr/>
          </p:nvSpPr>
          <p:spPr>
            <a:xfrm>
              <a:off x="8542303" y="1667483"/>
              <a:ext cx="46519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LAG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D7F52BED-51F2-F841-9AFF-B1D862569CBD}"/>
                </a:ext>
              </a:extLst>
            </p:cNvPr>
            <p:cNvSpPr txBox="1"/>
            <p:nvPr/>
          </p:nvSpPr>
          <p:spPr>
            <a:xfrm>
              <a:off x="9819806" y="1667483"/>
              <a:ext cx="68961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ILRB1****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E5E058ED-E902-EF44-8811-711C045BB070}"/>
                </a:ext>
              </a:extLst>
            </p:cNvPr>
            <p:cNvSpPr txBox="1"/>
            <p:nvPr/>
          </p:nvSpPr>
          <p:spPr>
            <a:xfrm>
              <a:off x="11097309" y="1667483"/>
              <a:ext cx="64953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LILRB2***</a:t>
              </a:r>
            </a:p>
          </p:txBody>
        </p:sp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8E188368-D72D-2D49-9C52-105FB98C85B1}"/>
                </a:ext>
              </a:extLst>
            </p:cNvPr>
            <p:cNvSpPr txBox="1"/>
            <p:nvPr/>
          </p:nvSpPr>
          <p:spPr>
            <a:xfrm>
              <a:off x="8542303" y="2998852"/>
              <a:ext cx="53251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DCD1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88F657E7-0095-6642-8CA0-87A55FF4F87D}"/>
                </a:ext>
              </a:extLst>
            </p:cNvPr>
            <p:cNvSpPr txBox="1"/>
            <p:nvPr/>
          </p:nvSpPr>
          <p:spPr>
            <a:xfrm>
              <a:off x="9819806" y="3008070"/>
              <a:ext cx="66556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D274****</a:t>
              </a:r>
            </a:p>
          </p:txBody>
        </p:sp>
        <p:sp>
          <p:nvSpPr>
            <p:cNvPr id="140" name="TextBox 139">
              <a:extLst>
                <a:ext uri="{FF2B5EF4-FFF2-40B4-BE49-F238E27FC236}">
                  <a16:creationId xmlns:a16="http://schemas.microsoft.com/office/drawing/2014/main" id="{25B56A56-F90A-C04C-8F0E-25D4ADA54F80}"/>
                </a:ext>
              </a:extLst>
            </p:cNvPr>
            <p:cNvSpPr txBox="1"/>
            <p:nvPr/>
          </p:nvSpPr>
          <p:spPr>
            <a:xfrm>
              <a:off x="11070058" y="3008070"/>
              <a:ext cx="88838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DCD1LG2****</a:t>
              </a:r>
            </a:p>
          </p:txBody>
        </p:sp>
        <p:sp>
          <p:nvSpPr>
            <p:cNvPr id="141" name="TextBox 140">
              <a:extLst>
                <a:ext uri="{FF2B5EF4-FFF2-40B4-BE49-F238E27FC236}">
                  <a16:creationId xmlns:a16="http://schemas.microsoft.com/office/drawing/2014/main" id="{7447B261-46F2-8D49-8E00-D7B0058E4554}"/>
                </a:ext>
              </a:extLst>
            </p:cNvPr>
            <p:cNvSpPr txBox="1"/>
            <p:nvPr/>
          </p:nvSpPr>
          <p:spPr>
            <a:xfrm>
              <a:off x="8596004" y="4222499"/>
              <a:ext cx="545342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VSIR***</a:t>
              </a:r>
            </a:p>
          </p:txBody>
        </p: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F14DAB79-D5AD-D44A-856C-7ED983F6EAA5}"/>
                </a:ext>
              </a:extLst>
            </p:cNvPr>
            <p:cNvSpPr txBox="1"/>
            <p:nvPr/>
          </p:nvSpPr>
          <p:spPr>
            <a:xfrm>
              <a:off x="9828674" y="4240935"/>
              <a:ext cx="665567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TLA4****</a:t>
              </a: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1710C38F-35E6-2C43-B2A2-80541ED2C13D}"/>
                </a:ext>
              </a:extLst>
            </p:cNvPr>
            <p:cNvSpPr txBox="1"/>
            <p:nvPr/>
          </p:nvSpPr>
          <p:spPr>
            <a:xfrm>
              <a:off x="11097309" y="4240935"/>
              <a:ext cx="546945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L10****</a:t>
              </a: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14645C1B-211D-564C-A936-55C524E65072}"/>
                </a:ext>
              </a:extLst>
            </p:cNvPr>
            <p:cNvSpPr txBox="1"/>
            <p:nvPr/>
          </p:nvSpPr>
          <p:spPr>
            <a:xfrm>
              <a:off x="8596004" y="5484938"/>
              <a:ext cx="51648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GFB1</a:t>
              </a: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9D955CBF-6A79-ED44-B461-1B7EFEFF4F7D}"/>
                </a:ext>
              </a:extLst>
            </p:cNvPr>
            <p:cNvSpPr txBox="1"/>
            <p:nvPr/>
          </p:nvSpPr>
          <p:spPr>
            <a:xfrm>
              <a:off x="9828674" y="5473800"/>
              <a:ext cx="67678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GFB2****</a:t>
              </a: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987C8EC3-2EBC-0C4A-94D2-2CBA5404BC23}"/>
                </a:ext>
              </a:extLst>
            </p:cNvPr>
            <p:cNvSpPr txBox="1"/>
            <p:nvPr/>
          </p:nvSpPr>
          <p:spPr>
            <a:xfrm>
              <a:off x="11080190" y="5484938"/>
              <a:ext cx="676788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GFB3****</a:t>
              </a:r>
            </a:p>
          </p:txBody>
        </p:sp>
        <p:cxnSp>
          <p:nvCxnSpPr>
            <p:cNvPr id="147" name="Straight Arrow Connector 146">
              <a:extLst>
                <a:ext uri="{FF2B5EF4-FFF2-40B4-BE49-F238E27FC236}">
                  <a16:creationId xmlns:a16="http://schemas.microsoft.com/office/drawing/2014/main" id="{D2B8BF76-2E91-8B4A-ACA6-26C025148072}"/>
                </a:ext>
              </a:extLst>
            </p:cNvPr>
            <p:cNvCxnSpPr/>
            <p:nvPr/>
          </p:nvCxnSpPr>
          <p:spPr>
            <a:xfrm flipV="1">
              <a:off x="8265634" y="574250"/>
              <a:ext cx="0" cy="5725239"/>
            </a:xfrm>
            <a:prstGeom prst="straightConnector1">
              <a:avLst/>
            </a:prstGeom>
            <a:ln>
              <a:solidFill>
                <a:schemeClr val="bg1">
                  <a:lumMod val="50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0A6C22CC-E813-4B45-8A64-CBE299BFC0DB}"/>
                </a:ext>
              </a:extLst>
            </p:cNvPr>
            <p:cNvSpPr txBox="1"/>
            <p:nvPr/>
          </p:nvSpPr>
          <p:spPr>
            <a:xfrm rot="16200000">
              <a:off x="7959300" y="3165180"/>
              <a:ext cx="612668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FPKM</a:t>
              </a:r>
            </a:p>
          </p:txBody>
        </p:sp>
        <p:sp>
          <p:nvSpPr>
            <p:cNvPr id="149" name="TextBox 148">
              <a:extLst>
                <a:ext uri="{FF2B5EF4-FFF2-40B4-BE49-F238E27FC236}">
                  <a16:creationId xmlns:a16="http://schemas.microsoft.com/office/drawing/2014/main" id="{85359E52-1BC6-1249-9669-40913CFC3528}"/>
                </a:ext>
              </a:extLst>
            </p:cNvPr>
            <p:cNvSpPr txBox="1"/>
            <p:nvPr/>
          </p:nvSpPr>
          <p:spPr>
            <a:xfrm>
              <a:off x="10241425" y="466528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****</a:t>
              </a:r>
            </a:p>
          </p:txBody>
        </p:sp>
        <p:sp>
          <p:nvSpPr>
            <p:cNvPr id="150" name="Rectangle 149">
              <a:extLst>
                <a:ext uri="{FF2B5EF4-FFF2-40B4-BE49-F238E27FC236}">
                  <a16:creationId xmlns:a16="http://schemas.microsoft.com/office/drawing/2014/main" id="{F5CBAF95-BC12-4E47-8C52-95E977845DB2}"/>
                </a:ext>
              </a:extLst>
            </p:cNvPr>
            <p:cNvSpPr/>
            <p:nvPr/>
          </p:nvSpPr>
          <p:spPr>
            <a:xfrm>
              <a:off x="8418556" y="1328715"/>
              <a:ext cx="3721155" cy="29206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51" name="Group 150">
              <a:extLst>
                <a:ext uri="{FF2B5EF4-FFF2-40B4-BE49-F238E27FC236}">
                  <a16:creationId xmlns:a16="http://schemas.microsoft.com/office/drawing/2014/main" id="{FDF2A844-7C8C-4747-820E-BEA48F8B7079}"/>
                </a:ext>
              </a:extLst>
            </p:cNvPr>
            <p:cNvGrpSpPr/>
            <p:nvPr/>
          </p:nvGrpSpPr>
          <p:grpSpPr>
            <a:xfrm>
              <a:off x="8419192" y="1213478"/>
              <a:ext cx="1129187" cy="500613"/>
              <a:chOff x="8419192" y="1213478"/>
              <a:chExt cx="1129187" cy="500613"/>
            </a:xfrm>
          </p:grpSpPr>
          <p:sp>
            <p:nvSpPr>
              <p:cNvPr id="268" name="TextBox 267">
                <a:extLst>
                  <a:ext uri="{FF2B5EF4-FFF2-40B4-BE49-F238E27FC236}">
                    <a16:creationId xmlns:a16="http://schemas.microsoft.com/office/drawing/2014/main" id="{2B3BD612-C01F-9B4A-8918-20BF7F42C3B5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TextBox 268">
                <a:extLst>
                  <a:ext uri="{FF2B5EF4-FFF2-40B4-BE49-F238E27FC236}">
                    <a16:creationId xmlns:a16="http://schemas.microsoft.com/office/drawing/2014/main" id="{CF67F134-8054-3A47-B650-7D28EBFC5C82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TextBox 269">
                <a:extLst>
                  <a:ext uri="{FF2B5EF4-FFF2-40B4-BE49-F238E27FC236}">
                    <a16:creationId xmlns:a16="http://schemas.microsoft.com/office/drawing/2014/main" id="{94EE654B-7E27-7549-8CA4-75BE77735BD0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1" name="TextBox 270">
                <a:extLst>
                  <a:ext uri="{FF2B5EF4-FFF2-40B4-BE49-F238E27FC236}">
                    <a16:creationId xmlns:a16="http://schemas.microsoft.com/office/drawing/2014/main" id="{7F579A1D-FC1A-C545-855F-4DE0FE203AEB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TextBox 271">
                <a:extLst>
                  <a:ext uri="{FF2B5EF4-FFF2-40B4-BE49-F238E27FC236}">
                    <a16:creationId xmlns:a16="http://schemas.microsoft.com/office/drawing/2014/main" id="{CC4B7023-3304-6943-B900-38D4D4C7B7FB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TextBox 272">
                <a:extLst>
                  <a:ext uri="{FF2B5EF4-FFF2-40B4-BE49-F238E27FC236}">
                    <a16:creationId xmlns:a16="http://schemas.microsoft.com/office/drawing/2014/main" id="{FD1FD91C-2093-9C4C-B998-75A702748CEE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74" name="TextBox 273">
                <a:extLst>
                  <a:ext uri="{FF2B5EF4-FFF2-40B4-BE49-F238E27FC236}">
                    <a16:creationId xmlns:a16="http://schemas.microsoft.com/office/drawing/2014/main" id="{024A77E0-135A-6B48-9031-A42D8405A46A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52" name="Group 151">
              <a:extLst>
                <a:ext uri="{FF2B5EF4-FFF2-40B4-BE49-F238E27FC236}">
                  <a16:creationId xmlns:a16="http://schemas.microsoft.com/office/drawing/2014/main" id="{53477CB1-57D4-7B47-A18F-7135FBBF5C7E}"/>
                </a:ext>
              </a:extLst>
            </p:cNvPr>
            <p:cNvGrpSpPr/>
            <p:nvPr/>
          </p:nvGrpSpPr>
          <p:grpSpPr>
            <a:xfrm>
              <a:off x="9714539" y="1220768"/>
              <a:ext cx="1129187" cy="500613"/>
              <a:chOff x="8419192" y="1213478"/>
              <a:chExt cx="1129187" cy="500613"/>
            </a:xfrm>
          </p:grpSpPr>
          <p:sp>
            <p:nvSpPr>
              <p:cNvPr id="261" name="TextBox 260">
                <a:extLst>
                  <a:ext uri="{FF2B5EF4-FFF2-40B4-BE49-F238E27FC236}">
                    <a16:creationId xmlns:a16="http://schemas.microsoft.com/office/drawing/2014/main" id="{CD1CA74D-C60D-8C40-936E-B2FB2985813B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TextBox 261">
                <a:extLst>
                  <a:ext uri="{FF2B5EF4-FFF2-40B4-BE49-F238E27FC236}">
                    <a16:creationId xmlns:a16="http://schemas.microsoft.com/office/drawing/2014/main" id="{CBBD4CC0-511A-E646-B1C3-0DEC4181FB07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TextBox 262">
                <a:extLst>
                  <a:ext uri="{FF2B5EF4-FFF2-40B4-BE49-F238E27FC236}">
                    <a16:creationId xmlns:a16="http://schemas.microsoft.com/office/drawing/2014/main" id="{B886416A-D3E0-BF47-8F91-4923FA135368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TextBox 263">
                <a:extLst>
                  <a:ext uri="{FF2B5EF4-FFF2-40B4-BE49-F238E27FC236}">
                    <a16:creationId xmlns:a16="http://schemas.microsoft.com/office/drawing/2014/main" id="{8EC9F7AA-BFFE-BF4B-B654-1FA5D55CE906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5" name="TextBox 264">
                <a:extLst>
                  <a:ext uri="{FF2B5EF4-FFF2-40B4-BE49-F238E27FC236}">
                    <a16:creationId xmlns:a16="http://schemas.microsoft.com/office/drawing/2014/main" id="{4A2A16AB-5838-0147-8DFD-77F3BCCE4064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FFFBBED0-7571-ED4D-9B0A-5BAB7A213C8F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67" name="TextBox 266">
                <a:extLst>
                  <a:ext uri="{FF2B5EF4-FFF2-40B4-BE49-F238E27FC236}">
                    <a16:creationId xmlns:a16="http://schemas.microsoft.com/office/drawing/2014/main" id="{F727FCFE-C53D-1E45-8F7F-F3BF5F9BEDFA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53" name="Group 152">
              <a:extLst>
                <a:ext uri="{FF2B5EF4-FFF2-40B4-BE49-F238E27FC236}">
                  <a16:creationId xmlns:a16="http://schemas.microsoft.com/office/drawing/2014/main" id="{7A58035A-6E43-E042-B130-5A783627F184}"/>
                </a:ext>
              </a:extLst>
            </p:cNvPr>
            <p:cNvGrpSpPr/>
            <p:nvPr/>
          </p:nvGrpSpPr>
          <p:grpSpPr>
            <a:xfrm>
              <a:off x="10988570" y="1235485"/>
              <a:ext cx="1129187" cy="500613"/>
              <a:chOff x="8419192" y="1213478"/>
              <a:chExt cx="1129187" cy="500613"/>
            </a:xfrm>
          </p:grpSpPr>
          <p:sp>
            <p:nvSpPr>
              <p:cNvPr id="254" name="TextBox 253">
                <a:extLst>
                  <a:ext uri="{FF2B5EF4-FFF2-40B4-BE49-F238E27FC236}">
                    <a16:creationId xmlns:a16="http://schemas.microsoft.com/office/drawing/2014/main" id="{150FD6BD-F7C7-544F-A6E5-78E7FDBB46D5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TextBox 254">
                <a:extLst>
                  <a:ext uri="{FF2B5EF4-FFF2-40B4-BE49-F238E27FC236}">
                    <a16:creationId xmlns:a16="http://schemas.microsoft.com/office/drawing/2014/main" id="{731D5655-3A02-384B-A81C-2F703F0FE100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6" name="TextBox 255">
                <a:extLst>
                  <a:ext uri="{FF2B5EF4-FFF2-40B4-BE49-F238E27FC236}">
                    <a16:creationId xmlns:a16="http://schemas.microsoft.com/office/drawing/2014/main" id="{FEB388A2-69BE-7D4D-B058-B4D0C90FC164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TextBox 256">
                <a:extLst>
                  <a:ext uri="{FF2B5EF4-FFF2-40B4-BE49-F238E27FC236}">
                    <a16:creationId xmlns:a16="http://schemas.microsoft.com/office/drawing/2014/main" id="{6C230B99-F985-4149-B498-2E013D091156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TextBox 257">
                <a:extLst>
                  <a:ext uri="{FF2B5EF4-FFF2-40B4-BE49-F238E27FC236}">
                    <a16:creationId xmlns:a16="http://schemas.microsoft.com/office/drawing/2014/main" id="{223D7BEF-A9E2-6C4F-A54B-183468D0607F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TextBox 258">
                <a:extLst>
                  <a:ext uri="{FF2B5EF4-FFF2-40B4-BE49-F238E27FC236}">
                    <a16:creationId xmlns:a16="http://schemas.microsoft.com/office/drawing/2014/main" id="{5E07241B-31E1-394D-B186-A0EED138A155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60" name="TextBox 259">
                <a:extLst>
                  <a:ext uri="{FF2B5EF4-FFF2-40B4-BE49-F238E27FC236}">
                    <a16:creationId xmlns:a16="http://schemas.microsoft.com/office/drawing/2014/main" id="{FD55B951-CCA6-394D-A867-848959DC3DB8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55003E63-1EB8-CE4B-BCAF-333C5218327D}"/>
                </a:ext>
              </a:extLst>
            </p:cNvPr>
            <p:cNvSpPr/>
            <p:nvPr/>
          </p:nvSpPr>
          <p:spPr>
            <a:xfrm>
              <a:off x="8437251" y="2479849"/>
              <a:ext cx="3721155" cy="29206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DADC9AA0-E813-D248-9000-2A95651DFA39}"/>
                </a:ext>
              </a:extLst>
            </p:cNvPr>
            <p:cNvGrpSpPr/>
            <p:nvPr/>
          </p:nvGrpSpPr>
          <p:grpSpPr>
            <a:xfrm>
              <a:off x="8442901" y="2384768"/>
              <a:ext cx="1129187" cy="500613"/>
              <a:chOff x="8419192" y="1213478"/>
              <a:chExt cx="1129187" cy="500613"/>
            </a:xfrm>
          </p:grpSpPr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381A747E-3726-9B48-A917-17532EA96E55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8" name="TextBox 247">
                <a:extLst>
                  <a:ext uri="{FF2B5EF4-FFF2-40B4-BE49-F238E27FC236}">
                    <a16:creationId xmlns:a16="http://schemas.microsoft.com/office/drawing/2014/main" id="{E60CCD1F-4665-4240-B3E9-EF1AFF44DCF8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9" name="TextBox 248">
                <a:extLst>
                  <a:ext uri="{FF2B5EF4-FFF2-40B4-BE49-F238E27FC236}">
                    <a16:creationId xmlns:a16="http://schemas.microsoft.com/office/drawing/2014/main" id="{386DD148-EE53-194C-833E-E1802C44D9F0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TextBox 249">
                <a:extLst>
                  <a:ext uri="{FF2B5EF4-FFF2-40B4-BE49-F238E27FC236}">
                    <a16:creationId xmlns:a16="http://schemas.microsoft.com/office/drawing/2014/main" id="{C0B6F280-0B5A-0A43-B1D4-04F249058E50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336FBB89-2632-7147-8345-6ABD2A44CC3D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TextBox 251">
                <a:extLst>
                  <a:ext uri="{FF2B5EF4-FFF2-40B4-BE49-F238E27FC236}">
                    <a16:creationId xmlns:a16="http://schemas.microsoft.com/office/drawing/2014/main" id="{86A97B2B-4965-F148-A594-F319090E5A8F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53" name="TextBox 252">
                <a:extLst>
                  <a:ext uri="{FF2B5EF4-FFF2-40B4-BE49-F238E27FC236}">
                    <a16:creationId xmlns:a16="http://schemas.microsoft.com/office/drawing/2014/main" id="{E3B166A7-6692-EB45-88E4-6C9F5EA16787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56" name="Group 155">
              <a:extLst>
                <a:ext uri="{FF2B5EF4-FFF2-40B4-BE49-F238E27FC236}">
                  <a16:creationId xmlns:a16="http://schemas.microsoft.com/office/drawing/2014/main" id="{67D8273F-796C-574B-93DC-54D4E871A669}"/>
                </a:ext>
              </a:extLst>
            </p:cNvPr>
            <p:cNvGrpSpPr/>
            <p:nvPr/>
          </p:nvGrpSpPr>
          <p:grpSpPr>
            <a:xfrm>
              <a:off x="9733234" y="2388272"/>
              <a:ext cx="1129187" cy="500613"/>
              <a:chOff x="8419192" y="1213478"/>
              <a:chExt cx="1129187" cy="500613"/>
            </a:xfrm>
          </p:grpSpPr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9AB80359-3B0D-B145-BA19-7AA36F6149B2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TextBox 240">
                <a:extLst>
                  <a:ext uri="{FF2B5EF4-FFF2-40B4-BE49-F238E27FC236}">
                    <a16:creationId xmlns:a16="http://schemas.microsoft.com/office/drawing/2014/main" id="{02646F94-CCDF-C049-AF11-8BE03C7E029C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E945AA80-D981-BB42-8E46-CAF77737DE68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4F86E5E2-BE16-D049-85CA-8F648BB1F076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TextBox 243">
                <a:extLst>
                  <a:ext uri="{FF2B5EF4-FFF2-40B4-BE49-F238E27FC236}">
                    <a16:creationId xmlns:a16="http://schemas.microsoft.com/office/drawing/2014/main" id="{6373B64E-DC47-9D48-88AF-CB0BB8C2D0D6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TextBox 244">
                <a:extLst>
                  <a:ext uri="{FF2B5EF4-FFF2-40B4-BE49-F238E27FC236}">
                    <a16:creationId xmlns:a16="http://schemas.microsoft.com/office/drawing/2014/main" id="{0F5D99A6-0D0C-A04E-8D26-143828DBEF81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46" name="TextBox 245">
                <a:extLst>
                  <a:ext uri="{FF2B5EF4-FFF2-40B4-BE49-F238E27FC236}">
                    <a16:creationId xmlns:a16="http://schemas.microsoft.com/office/drawing/2014/main" id="{0A8BCEA7-34B0-2641-91AD-123D1A90DF54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57" name="Group 156">
              <a:extLst>
                <a:ext uri="{FF2B5EF4-FFF2-40B4-BE49-F238E27FC236}">
                  <a16:creationId xmlns:a16="http://schemas.microsoft.com/office/drawing/2014/main" id="{54267120-A7BD-7847-9836-96FCBF13CFDA}"/>
                </a:ext>
              </a:extLst>
            </p:cNvPr>
            <p:cNvGrpSpPr/>
            <p:nvPr/>
          </p:nvGrpSpPr>
          <p:grpSpPr>
            <a:xfrm>
              <a:off x="11008227" y="2387628"/>
              <a:ext cx="1129187" cy="500613"/>
              <a:chOff x="8419192" y="1213478"/>
              <a:chExt cx="1129187" cy="500613"/>
            </a:xfrm>
          </p:grpSpPr>
          <p:sp>
            <p:nvSpPr>
              <p:cNvPr id="233" name="TextBox 232">
                <a:extLst>
                  <a:ext uri="{FF2B5EF4-FFF2-40B4-BE49-F238E27FC236}">
                    <a16:creationId xmlns:a16="http://schemas.microsoft.com/office/drawing/2014/main" id="{EB1888AD-524F-2548-8B2D-9FC6A8C3801D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TextBox 233">
                <a:extLst>
                  <a:ext uri="{FF2B5EF4-FFF2-40B4-BE49-F238E27FC236}">
                    <a16:creationId xmlns:a16="http://schemas.microsoft.com/office/drawing/2014/main" id="{6751CC32-13FE-5D48-A91E-AE6044667B32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TextBox 234">
                <a:extLst>
                  <a:ext uri="{FF2B5EF4-FFF2-40B4-BE49-F238E27FC236}">
                    <a16:creationId xmlns:a16="http://schemas.microsoft.com/office/drawing/2014/main" id="{1B5259FE-C4B7-3743-9021-564ABD7CEEF9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6" name="TextBox 235">
                <a:extLst>
                  <a:ext uri="{FF2B5EF4-FFF2-40B4-BE49-F238E27FC236}">
                    <a16:creationId xmlns:a16="http://schemas.microsoft.com/office/drawing/2014/main" id="{87FDD18A-C37B-2C41-BBAD-C01F806C2F1C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TextBox 236">
                <a:extLst>
                  <a:ext uri="{FF2B5EF4-FFF2-40B4-BE49-F238E27FC236}">
                    <a16:creationId xmlns:a16="http://schemas.microsoft.com/office/drawing/2014/main" id="{4073BE0D-88CA-0841-B6B9-670AE95C8A77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TextBox 237">
                <a:extLst>
                  <a:ext uri="{FF2B5EF4-FFF2-40B4-BE49-F238E27FC236}">
                    <a16:creationId xmlns:a16="http://schemas.microsoft.com/office/drawing/2014/main" id="{4E8C0975-AEC4-CE4C-96C4-7260F94266AB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39" name="TextBox 238">
                <a:extLst>
                  <a:ext uri="{FF2B5EF4-FFF2-40B4-BE49-F238E27FC236}">
                    <a16:creationId xmlns:a16="http://schemas.microsoft.com/office/drawing/2014/main" id="{6B75B7A6-AF2B-174E-8338-531003220362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FB5EA8B2-7A2A-9B41-BCB3-CFEADE47CD4E}"/>
                </a:ext>
              </a:extLst>
            </p:cNvPr>
            <p:cNvSpPr/>
            <p:nvPr/>
          </p:nvSpPr>
          <p:spPr>
            <a:xfrm>
              <a:off x="8437250" y="3803869"/>
              <a:ext cx="3721155" cy="29206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59" name="Group 158">
              <a:extLst>
                <a:ext uri="{FF2B5EF4-FFF2-40B4-BE49-F238E27FC236}">
                  <a16:creationId xmlns:a16="http://schemas.microsoft.com/office/drawing/2014/main" id="{1FB46F8A-9A7F-AE4E-B725-10B4B481AB90}"/>
                </a:ext>
              </a:extLst>
            </p:cNvPr>
            <p:cNvGrpSpPr/>
            <p:nvPr/>
          </p:nvGrpSpPr>
          <p:grpSpPr>
            <a:xfrm>
              <a:off x="8475474" y="3679664"/>
              <a:ext cx="1129187" cy="500613"/>
              <a:chOff x="8419192" y="1213478"/>
              <a:chExt cx="1129187" cy="500613"/>
            </a:xfrm>
          </p:grpSpPr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CD693B44-306B-D249-B325-2DA39B7B77C7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BED58154-70D7-9C4C-B33C-EFA5129BAE73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2CD5A241-7175-7849-9E8D-19A330B65DAB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A6B02187-D375-2645-9B52-A3760859BADC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0" name="TextBox 229">
                <a:extLst>
                  <a:ext uri="{FF2B5EF4-FFF2-40B4-BE49-F238E27FC236}">
                    <a16:creationId xmlns:a16="http://schemas.microsoft.com/office/drawing/2014/main" id="{EDF29138-9997-B74A-BA72-A5E6ED1361AA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1" name="TextBox 230">
                <a:extLst>
                  <a:ext uri="{FF2B5EF4-FFF2-40B4-BE49-F238E27FC236}">
                    <a16:creationId xmlns:a16="http://schemas.microsoft.com/office/drawing/2014/main" id="{A48AF10B-69C2-8446-A128-94861C57C125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32" name="TextBox 231">
                <a:extLst>
                  <a:ext uri="{FF2B5EF4-FFF2-40B4-BE49-F238E27FC236}">
                    <a16:creationId xmlns:a16="http://schemas.microsoft.com/office/drawing/2014/main" id="{DDE2811D-D1B3-AF43-B14A-54D60CBF1AF9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60" name="Group 159">
              <a:extLst>
                <a:ext uri="{FF2B5EF4-FFF2-40B4-BE49-F238E27FC236}">
                  <a16:creationId xmlns:a16="http://schemas.microsoft.com/office/drawing/2014/main" id="{AF555A98-E3AE-4C4A-AA35-C567995301E4}"/>
                </a:ext>
              </a:extLst>
            </p:cNvPr>
            <p:cNvGrpSpPr/>
            <p:nvPr/>
          </p:nvGrpSpPr>
          <p:grpSpPr>
            <a:xfrm>
              <a:off x="9703013" y="3694381"/>
              <a:ext cx="1129187" cy="500613"/>
              <a:chOff x="8419192" y="1213478"/>
              <a:chExt cx="1129187" cy="500613"/>
            </a:xfrm>
          </p:grpSpPr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id="{A3C0AFB7-186A-2543-B7E0-6C555B392ADE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TextBox 219">
                <a:extLst>
                  <a:ext uri="{FF2B5EF4-FFF2-40B4-BE49-F238E27FC236}">
                    <a16:creationId xmlns:a16="http://schemas.microsoft.com/office/drawing/2014/main" id="{2FB175A5-BD1E-864D-9CE2-85C97A03035F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A76BD912-148D-8740-B933-78FE26667BEB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937FF54D-9123-6A4F-9F08-A83E9A64607C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7304B5E1-B4E4-8146-A503-3AB95FA7F66D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B8AAA073-0527-9541-AF41-4932B3EF45D7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6A78F745-8273-984B-8B0C-5364F73F91A0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61" name="Group 160">
              <a:extLst>
                <a:ext uri="{FF2B5EF4-FFF2-40B4-BE49-F238E27FC236}">
                  <a16:creationId xmlns:a16="http://schemas.microsoft.com/office/drawing/2014/main" id="{536C6067-EEFB-8F45-B67F-898F5530FD8B}"/>
                </a:ext>
              </a:extLst>
            </p:cNvPr>
            <p:cNvGrpSpPr/>
            <p:nvPr/>
          </p:nvGrpSpPr>
          <p:grpSpPr>
            <a:xfrm>
              <a:off x="10998222" y="3694060"/>
              <a:ext cx="1129187" cy="500613"/>
              <a:chOff x="8419192" y="1213478"/>
              <a:chExt cx="1129187" cy="500613"/>
            </a:xfrm>
          </p:grpSpPr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F931188A-CA69-444C-BFCF-24CB62676894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TextBox 212">
                <a:extLst>
                  <a:ext uri="{FF2B5EF4-FFF2-40B4-BE49-F238E27FC236}">
                    <a16:creationId xmlns:a16="http://schemas.microsoft.com/office/drawing/2014/main" id="{6B9F7344-6361-9946-8CD7-B95950C4FE4A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CA7E4A69-687A-6A40-B8B8-F412368343CD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TextBox 214">
                <a:extLst>
                  <a:ext uri="{FF2B5EF4-FFF2-40B4-BE49-F238E27FC236}">
                    <a16:creationId xmlns:a16="http://schemas.microsoft.com/office/drawing/2014/main" id="{EE90CC02-8E0F-624C-940F-83D49CCB43FD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TextBox 215">
                <a:extLst>
                  <a:ext uri="{FF2B5EF4-FFF2-40B4-BE49-F238E27FC236}">
                    <a16:creationId xmlns:a16="http://schemas.microsoft.com/office/drawing/2014/main" id="{2BA69B27-F68C-AA47-B949-5F9DDEC35965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TextBox 216">
                <a:extLst>
                  <a:ext uri="{FF2B5EF4-FFF2-40B4-BE49-F238E27FC236}">
                    <a16:creationId xmlns:a16="http://schemas.microsoft.com/office/drawing/2014/main" id="{26903D14-47A1-304C-A006-B1DDC0B3C42B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18" name="TextBox 217">
                <a:extLst>
                  <a:ext uri="{FF2B5EF4-FFF2-40B4-BE49-F238E27FC236}">
                    <a16:creationId xmlns:a16="http://schemas.microsoft.com/office/drawing/2014/main" id="{73B0BC88-171E-EA49-834F-A20A7595B80B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1FA5F309-5F70-A14E-8E57-264259A667C5}"/>
                </a:ext>
              </a:extLst>
            </p:cNvPr>
            <p:cNvSpPr/>
            <p:nvPr/>
          </p:nvSpPr>
          <p:spPr>
            <a:xfrm>
              <a:off x="8499183" y="5055791"/>
              <a:ext cx="3721155" cy="29206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63" name="Group 162">
              <a:extLst>
                <a:ext uri="{FF2B5EF4-FFF2-40B4-BE49-F238E27FC236}">
                  <a16:creationId xmlns:a16="http://schemas.microsoft.com/office/drawing/2014/main" id="{3EE60321-BD62-1945-A0A5-33DDB7DECEC1}"/>
                </a:ext>
              </a:extLst>
            </p:cNvPr>
            <p:cNvGrpSpPr/>
            <p:nvPr/>
          </p:nvGrpSpPr>
          <p:grpSpPr>
            <a:xfrm>
              <a:off x="8496558" y="4951514"/>
              <a:ext cx="1129187" cy="500613"/>
              <a:chOff x="8419192" y="1213478"/>
              <a:chExt cx="1129187" cy="500613"/>
            </a:xfrm>
          </p:grpSpPr>
          <p:sp>
            <p:nvSpPr>
              <p:cNvPr id="205" name="TextBox 204">
                <a:extLst>
                  <a:ext uri="{FF2B5EF4-FFF2-40B4-BE49-F238E27FC236}">
                    <a16:creationId xmlns:a16="http://schemas.microsoft.com/office/drawing/2014/main" id="{210B5D2E-5112-1648-AA7F-1C2A523F5502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E7C5E114-348C-F841-ABF8-5CBC830344C7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1E12F063-39D8-3049-A393-6470E29D996A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TextBox 207">
                <a:extLst>
                  <a:ext uri="{FF2B5EF4-FFF2-40B4-BE49-F238E27FC236}">
                    <a16:creationId xmlns:a16="http://schemas.microsoft.com/office/drawing/2014/main" id="{A0CBD6B3-70A5-7243-B51F-F3C5567A0529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TextBox 208">
                <a:extLst>
                  <a:ext uri="{FF2B5EF4-FFF2-40B4-BE49-F238E27FC236}">
                    <a16:creationId xmlns:a16="http://schemas.microsoft.com/office/drawing/2014/main" id="{9CD14FDD-482F-7A45-88E1-3DCD8BB40BC2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TextBox 209">
                <a:extLst>
                  <a:ext uri="{FF2B5EF4-FFF2-40B4-BE49-F238E27FC236}">
                    <a16:creationId xmlns:a16="http://schemas.microsoft.com/office/drawing/2014/main" id="{D52F9D36-A973-A946-8A7F-AE1A9D490DA0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11" name="TextBox 210">
                <a:extLst>
                  <a:ext uri="{FF2B5EF4-FFF2-40B4-BE49-F238E27FC236}">
                    <a16:creationId xmlns:a16="http://schemas.microsoft.com/office/drawing/2014/main" id="{487B3641-BC2B-C246-8728-7AA9ABBEFDA2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64" name="Group 163">
              <a:extLst>
                <a:ext uri="{FF2B5EF4-FFF2-40B4-BE49-F238E27FC236}">
                  <a16:creationId xmlns:a16="http://schemas.microsoft.com/office/drawing/2014/main" id="{95EF8C26-05C7-D547-9E97-EE00D16E3EC6}"/>
                </a:ext>
              </a:extLst>
            </p:cNvPr>
            <p:cNvGrpSpPr/>
            <p:nvPr/>
          </p:nvGrpSpPr>
          <p:grpSpPr>
            <a:xfrm>
              <a:off x="9756675" y="4955643"/>
              <a:ext cx="1129187" cy="500613"/>
              <a:chOff x="8419192" y="1213478"/>
              <a:chExt cx="1129187" cy="500613"/>
            </a:xfrm>
          </p:grpSpPr>
          <p:sp>
            <p:nvSpPr>
              <p:cNvPr id="198" name="TextBox 197">
                <a:extLst>
                  <a:ext uri="{FF2B5EF4-FFF2-40B4-BE49-F238E27FC236}">
                    <a16:creationId xmlns:a16="http://schemas.microsoft.com/office/drawing/2014/main" id="{E2BE5B84-B779-044C-8213-400CDC444298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TextBox 198">
                <a:extLst>
                  <a:ext uri="{FF2B5EF4-FFF2-40B4-BE49-F238E27FC236}">
                    <a16:creationId xmlns:a16="http://schemas.microsoft.com/office/drawing/2014/main" id="{5AD2249E-8FEB-1A4C-8406-4FAB383EB896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94632265-18BB-4B4F-AFBD-7FCFF973E6AB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EE2EF0D1-B29F-A046-9007-F8F2906A3385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4AE1F799-D2E0-5C4D-97D2-9B749B8988D3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TextBox 202">
                <a:extLst>
                  <a:ext uri="{FF2B5EF4-FFF2-40B4-BE49-F238E27FC236}">
                    <a16:creationId xmlns:a16="http://schemas.microsoft.com/office/drawing/2014/main" id="{BDED45E6-D1AD-3140-9C8C-76EC819B69EF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204" name="TextBox 203">
                <a:extLst>
                  <a:ext uri="{FF2B5EF4-FFF2-40B4-BE49-F238E27FC236}">
                    <a16:creationId xmlns:a16="http://schemas.microsoft.com/office/drawing/2014/main" id="{4DA4E9E1-5184-7B4B-86EA-F26F59803A6E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65" name="Group 164">
              <a:extLst>
                <a:ext uri="{FF2B5EF4-FFF2-40B4-BE49-F238E27FC236}">
                  <a16:creationId xmlns:a16="http://schemas.microsoft.com/office/drawing/2014/main" id="{361C2608-0762-7B4C-B1B1-D61A82F2C3B1}"/>
                </a:ext>
              </a:extLst>
            </p:cNvPr>
            <p:cNvGrpSpPr/>
            <p:nvPr/>
          </p:nvGrpSpPr>
          <p:grpSpPr>
            <a:xfrm>
              <a:off x="11012708" y="4958804"/>
              <a:ext cx="1129187" cy="500613"/>
              <a:chOff x="8419192" y="1213478"/>
              <a:chExt cx="1129187" cy="500613"/>
            </a:xfrm>
          </p:grpSpPr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46E2A1DC-0199-AA43-8996-38B0F51B19D2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EA665D22-D67B-BA49-B2DB-403A3795D50D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3" name="TextBox 192">
                <a:extLst>
                  <a:ext uri="{FF2B5EF4-FFF2-40B4-BE49-F238E27FC236}">
                    <a16:creationId xmlns:a16="http://schemas.microsoft.com/office/drawing/2014/main" id="{FA3C0686-E865-214F-9CE2-9A1D054F5DBA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4" name="TextBox 193">
                <a:extLst>
                  <a:ext uri="{FF2B5EF4-FFF2-40B4-BE49-F238E27FC236}">
                    <a16:creationId xmlns:a16="http://schemas.microsoft.com/office/drawing/2014/main" id="{141093AF-8512-2542-8756-C7F14476B234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TextBox 194">
                <a:extLst>
                  <a:ext uri="{FF2B5EF4-FFF2-40B4-BE49-F238E27FC236}">
                    <a16:creationId xmlns:a16="http://schemas.microsoft.com/office/drawing/2014/main" id="{94931347-8828-F047-8BF8-03414833425D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TextBox 195">
                <a:extLst>
                  <a:ext uri="{FF2B5EF4-FFF2-40B4-BE49-F238E27FC236}">
                    <a16:creationId xmlns:a16="http://schemas.microsoft.com/office/drawing/2014/main" id="{6EBDE27C-A486-A645-83D1-653772BA85C8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197" name="TextBox 196">
                <a:extLst>
                  <a:ext uri="{FF2B5EF4-FFF2-40B4-BE49-F238E27FC236}">
                    <a16:creationId xmlns:a16="http://schemas.microsoft.com/office/drawing/2014/main" id="{2FC33E93-6DA5-014E-B06D-EB7E96C11498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599D791A-C13B-094C-9314-F0C9FCD5EFB8}"/>
                </a:ext>
              </a:extLst>
            </p:cNvPr>
            <p:cNvSpPr/>
            <p:nvPr/>
          </p:nvSpPr>
          <p:spPr>
            <a:xfrm>
              <a:off x="8437250" y="6344517"/>
              <a:ext cx="3721155" cy="29206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67" name="Group 166">
              <a:extLst>
                <a:ext uri="{FF2B5EF4-FFF2-40B4-BE49-F238E27FC236}">
                  <a16:creationId xmlns:a16="http://schemas.microsoft.com/office/drawing/2014/main" id="{67B3ACEC-79BF-C443-9CC4-D9AF96BCE993}"/>
                </a:ext>
              </a:extLst>
            </p:cNvPr>
            <p:cNvGrpSpPr/>
            <p:nvPr/>
          </p:nvGrpSpPr>
          <p:grpSpPr>
            <a:xfrm>
              <a:off x="8466337" y="6229265"/>
              <a:ext cx="1129187" cy="500613"/>
              <a:chOff x="8419192" y="1213478"/>
              <a:chExt cx="1129187" cy="500613"/>
            </a:xfrm>
          </p:grpSpPr>
          <p:sp>
            <p:nvSpPr>
              <p:cNvPr id="184" name="TextBox 183">
                <a:extLst>
                  <a:ext uri="{FF2B5EF4-FFF2-40B4-BE49-F238E27FC236}">
                    <a16:creationId xmlns:a16="http://schemas.microsoft.com/office/drawing/2014/main" id="{064C995B-254F-6042-9104-DD4D2258DDEC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5" name="TextBox 184">
                <a:extLst>
                  <a:ext uri="{FF2B5EF4-FFF2-40B4-BE49-F238E27FC236}">
                    <a16:creationId xmlns:a16="http://schemas.microsoft.com/office/drawing/2014/main" id="{9F0E082F-65BF-2640-91EC-A58C64C28652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6" name="TextBox 185">
                <a:extLst>
                  <a:ext uri="{FF2B5EF4-FFF2-40B4-BE49-F238E27FC236}">
                    <a16:creationId xmlns:a16="http://schemas.microsoft.com/office/drawing/2014/main" id="{D157281E-94E8-D14D-8A14-D8FC62296D11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1FF05EE3-68B2-8D40-8C8E-57FCDE4A60F2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8" name="TextBox 187">
                <a:extLst>
                  <a:ext uri="{FF2B5EF4-FFF2-40B4-BE49-F238E27FC236}">
                    <a16:creationId xmlns:a16="http://schemas.microsoft.com/office/drawing/2014/main" id="{8200A57A-6DDA-164C-8FE5-BD3376409669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TextBox 188">
                <a:extLst>
                  <a:ext uri="{FF2B5EF4-FFF2-40B4-BE49-F238E27FC236}">
                    <a16:creationId xmlns:a16="http://schemas.microsoft.com/office/drawing/2014/main" id="{0E4AF6E4-E627-4D43-B06B-959824C22820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190" name="TextBox 189">
                <a:extLst>
                  <a:ext uri="{FF2B5EF4-FFF2-40B4-BE49-F238E27FC236}">
                    <a16:creationId xmlns:a16="http://schemas.microsoft.com/office/drawing/2014/main" id="{F1A40E9B-8DC0-2A4A-8B01-B4BC317464BA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68" name="Group 167">
              <a:extLst>
                <a:ext uri="{FF2B5EF4-FFF2-40B4-BE49-F238E27FC236}">
                  <a16:creationId xmlns:a16="http://schemas.microsoft.com/office/drawing/2014/main" id="{D9983C6B-A0B4-4343-8C4D-E0817A0ED150}"/>
                </a:ext>
              </a:extLst>
            </p:cNvPr>
            <p:cNvGrpSpPr/>
            <p:nvPr/>
          </p:nvGrpSpPr>
          <p:grpSpPr>
            <a:xfrm>
              <a:off x="9748558" y="6229129"/>
              <a:ext cx="1129187" cy="500613"/>
              <a:chOff x="8419192" y="1213478"/>
              <a:chExt cx="1129187" cy="500613"/>
            </a:xfrm>
          </p:grpSpPr>
          <p:sp>
            <p:nvSpPr>
              <p:cNvPr id="177" name="TextBox 176">
                <a:extLst>
                  <a:ext uri="{FF2B5EF4-FFF2-40B4-BE49-F238E27FC236}">
                    <a16:creationId xmlns:a16="http://schemas.microsoft.com/office/drawing/2014/main" id="{8FC666B9-9A00-9B42-9139-1BC13CF0E415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8" name="TextBox 177">
                <a:extLst>
                  <a:ext uri="{FF2B5EF4-FFF2-40B4-BE49-F238E27FC236}">
                    <a16:creationId xmlns:a16="http://schemas.microsoft.com/office/drawing/2014/main" id="{D4014D1A-C123-DE44-B280-A1C274F223D9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9" name="TextBox 178">
                <a:extLst>
                  <a:ext uri="{FF2B5EF4-FFF2-40B4-BE49-F238E27FC236}">
                    <a16:creationId xmlns:a16="http://schemas.microsoft.com/office/drawing/2014/main" id="{794A8638-CDBB-AB40-AE01-2329B8F25496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0" name="TextBox 179">
                <a:extLst>
                  <a:ext uri="{FF2B5EF4-FFF2-40B4-BE49-F238E27FC236}">
                    <a16:creationId xmlns:a16="http://schemas.microsoft.com/office/drawing/2014/main" id="{F2A0B29B-0429-4A40-8C23-8E07681F4A57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1" name="TextBox 180">
                <a:extLst>
                  <a:ext uri="{FF2B5EF4-FFF2-40B4-BE49-F238E27FC236}">
                    <a16:creationId xmlns:a16="http://schemas.microsoft.com/office/drawing/2014/main" id="{2C3DD998-1C84-7F45-A81B-99F07FCA3664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TextBox 181">
                <a:extLst>
                  <a:ext uri="{FF2B5EF4-FFF2-40B4-BE49-F238E27FC236}">
                    <a16:creationId xmlns:a16="http://schemas.microsoft.com/office/drawing/2014/main" id="{73A18531-69F2-D64D-BC93-0C4D2972BB11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183" name="TextBox 182">
                <a:extLst>
                  <a:ext uri="{FF2B5EF4-FFF2-40B4-BE49-F238E27FC236}">
                    <a16:creationId xmlns:a16="http://schemas.microsoft.com/office/drawing/2014/main" id="{16BBCD7C-32EC-894D-A193-EE10A342B306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  <p:grpSp>
          <p:nvGrpSpPr>
            <p:cNvPr id="169" name="Group 168">
              <a:extLst>
                <a:ext uri="{FF2B5EF4-FFF2-40B4-BE49-F238E27FC236}">
                  <a16:creationId xmlns:a16="http://schemas.microsoft.com/office/drawing/2014/main" id="{2B89E067-D303-4742-9FF3-FEFBE1880B1C}"/>
                </a:ext>
              </a:extLst>
            </p:cNvPr>
            <p:cNvGrpSpPr/>
            <p:nvPr/>
          </p:nvGrpSpPr>
          <p:grpSpPr>
            <a:xfrm>
              <a:off x="11020723" y="6240240"/>
              <a:ext cx="1129187" cy="500613"/>
              <a:chOff x="8419192" y="1213478"/>
              <a:chExt cx="1129187" cy="500613"/>
            </a:xfrm>
          </p:grpSpPr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B6EC0FDA-8F39-8243-8499-298D28123E62}"/>
                  </a:ext>
                </a:extLst>
              </p:cNvPr>
              <p:cNvSpPr txBox="1"/>
              <p:nvPr/>
            </p:nvSpPr>
            <p:spPr>
              <a:xfrm rot="18413975">
                <a:off x="8311951" y="1326499"/>
                <a:ext cx="42992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F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1F6CEE38-2F03-794B-8B80-723F9B5DA40A}"/>
                  </a:ext>
                </a:extLst>
              </p:cNvPr>
              <p:cNvSpPr txBox="1"/>
              <p:nvPr/>
            </p:nvSpPr>
            <p:spPr>
              <a:xfrm rot="18413975">
                <a:off x="8474441" y="1335231"/>
                <a:ext cx="4363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-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st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0C5F1491-885B-9C40-A473-B52E7D20D09E}"/>
                  </a:ext>
                </a:extLst>
              </p:cNvPr>
              <p:cNvSpPr txBox="1"/>
              <p:nvPr/>
            </p:nvSpPr>
            <p:spPr>
              <a:xfrm rot="18413975">
                <a:off x="8654574" y="1326498"/>
                <a:ext cx="40748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ron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TextBox 172">
                <a:extLst>
                  <a:ext uri="{FF2B5EF4-FFF2-40B4-BE49-F238E27FC236}">
                    <a16:creationId xmlns:a16="http://schemas.microsoft.com/office/drawing/2014/main" id="{228AFC13-A196-F743-A2A4-773B1DA07081}"/>
                  </a:ext>
                </a:extLst>
              </p:cNvPr>
              <p:cNvSpPr txBox="1"/>
              <p:nvPr/>
            </p:nvSpPr>
            <p:spPr>
              <a:xfrm rot="18413975">
                <a:off x="8746855" y="1363353"/>
                <a:ext cx="48282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Oligod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TextBox 173">
                <a:extLst>
                  <a:ext uri="{FF2B5EF4-FFF2-40B4-BE49-F238E27FC236}">
                    <a16:creationId xmlns:a16="http://schemas.microsoft.com/office/drawing/2014/main" id="{794C2E43-3272-2142-B966-B2436F753A42}"/>
                  </a:ext>
                </a:extLst>
              </p:cNvPr>
              <p:cNvSpPr txBox="1"/>
              <p:nvPr/>
            </p:nvSpPr>
            <p:spPr>
              <a:xfrm rot="18413975">
                <a:off x="8892808" y="1363354"/>
                <a:ext cx="48603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Mac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TextBox 174">
                <a:extLst>
                  <a:ext uri="{FF2B5EF4-FFF2-40B4-BE49-F238E27FC236}">
                    <a16:creationId xmlns:a16="http://schemas.microsoft.com/office/drawing/2014/main" id="{026C018D-0384-D44C-A1C6-CF49EE7A7B0B}"/>
                  </a:ext>
                </a:extLst>
              </p:cNvPr>
              <p:cNvSpPr txBox="1"/>
              <p:nvPr/>
            </p:nvSpPr>
            <p:spPr>
              <a:xfrm rot="18413975">
                <a:off x="9172890" y="1301181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C</a:t>
                </a:r>
              </a:p>
            </p:txBody>
          </p:sp>
          <p:sp>
            <p:nvSpPr>
              <p:cNvPr id="176" name="TextBox 175">
                <a:extLst>
                  <a:ext uri="{FF2B5EF4-FFF2-40B4-BE49-F238E27FC236}">
                    <a16:creationId xmlns:a16="http://schemas.microsoft.com/office/drawing/2014/main" id="{AB6A20BD-C940-9840-8F4D-256D8FC60AB0}"/>
                  </a:ext>
                </a:extLst>
              </p:cNvPr>
              <p:cNvSpPr txBox="1"/>
              <p:nvPr/>
            </p:nvSpPr>
            <p:spPr>
              <a:xfrm rot="18413975">
                <a:off x="9196840" y="1349573"/>
                <a:ext cx="4876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rtex</a:t>
                </a:r>
              </a:p>
            </p:txBody>
          </p:sp>
        </p:grp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F793B871-A3AA-7E4B-95F6-2452D4B46EBB}"/>
              </a:ext>
            </a:extLst>
          </p:cNvPr>
          <p:cNvSpPr txBox="1"/>
          <p:nvPr/>
        </p:nvSpPr>
        <p:spPr>
          <a:xfrm>
            <a:off x="9068075" y="1029897"/>
            <a:ext cx="2468087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ene expression in brain cell populations in the absence of </a:t>
            </a:r>
            <a:r>
              <a:rPr lang="en-U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 cells.</a:t>
            </a:r>
          </a:p>
          <a:p>
            <a:pPr algn="just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raphs show expression of selected genes expressed as 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Fragments Per Kilobase of transcript per Million mapped reads (FPKM) across six different brain-derived cell types, with various numbers of donors (n) per cell type; foetal astrocytes (F-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s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n=6), adult astrocytes (A-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Ast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n=12), neurons (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Nron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n=1), oligodendrocytes (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Oligod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n=5), microglia/macrophage (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MiMac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, n=3), endothelial cells (EC, n=2) and whole cortex (Cortex, n=4). Bars show standard deviation from mean. Gene names are shown with asterisks where gene expression across the panel is significantly different (using one way ANOVA); *P&lt;0.05, **P&lt;0.01, ****P&lt;0.0001. This data was downloaded from the study of Zhang et al (2014). Expression of any gene can be viewed within this dataset using the tool at </a:t>
            </a:r>
            <a:r>
              <a:rPr lang="en-GB" sz="800" dirty="0" err="1">
                <a:latin typeface="Arial" panose="020B0604020202020204" pitchFamily="34" charset="0"/>
                <a:cs typeface="Arial" panose="020B0604020202020204" pitchFamily="34" charset="0"/>
              </a:rPr>
              <a:t>brainrnaseq.org</a:t>
            </a:r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19B1E36-870B-714C-B4AB-FB4AB9CB2CBA}"/>
              </a:ext>
            </a:extLst>
          </p:cNvPr>
          <p:cNvSpPr txBox="1"/>
          <p:nvPr/>
        </p:nvSpPr>
        <p:spPr>
          <a:xfrm>
            <a:off x="8763000" y="241300"/>
            <a:ext cx="19930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Supplementary Figure 4 </a:t>
            </a:r>
          </a:p>
        </p:txBody>
      </p:sp>
    </p:spTree>
    <p:extLst>
      <p:ext uri="{BB962C8B-B14F-4D97-AF65-F5344CB8AC3E}">
        <p14:creationId xmlns:p14="http://schemas.microsoft.com/office/powerpoint/2010/main" val="36872427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27</Words>
  <Application>Microsoft Macintosh PowerPoint</Application>
  <PresentationFormat>Widescreen</PresentationFormat>
  <Paragraphs>2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5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ca Watson</dc:creator>
  <cp:lastModifiedBy>Erica Watson</cp:lastModifiedBy>
  <cp:revision>4</cp:revision>
  <cp:lastPrinted>2019-07-01T16:05:59Z</cp:lastPrinted>
  <dcterms:created xsi:type="dcterms:W3CDTF">2019-06-11T19:09:55Z</dcterms:created>
  <dcterms:modified xsi:type="dcterms:W3CDTF">2019-07-01T16:06:24Z</dcterms:modified>
</cp:coreProperties>
</file>